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8" r:id="rId3"/>
    <p:sldId id="259" r:id="rId4"/>
    <p:sldId id="260" r:id="rId5"/>
    <p:sldId id="277" r:id="rId6"/>
    <p:sldId id="261" r:id="rId7"/>
    <p:sldId id="264" r:id="rId8"/>
    <p:sldId id="265" r:id="rId9"/>
    <p:sldId id="278" r:id="rId10"/>
    <p:sldId id="279" r:id="rId11"/>
    <p:sldId id="280" r:id="rId12"/>
    <p:sldId id="281" r:id="rId13"/>
    <p:sldId id="282" r:id="rId14"/>
    <p:sldId id="283" r:id="rId15"/>
    <p:sldId id="284" r:id="rId16"/>
    <p:sldId id="285" r:id="rId17"/>
    <p:sldId id="286" r:id="rId18"/>
    <p:sldId id="287" r:id="rId1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56AFC3C-E2E3-1248-B6E0-249E7406E605}" v="2" dt="2021-06-26T15:48:52.33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455"/>
    <p:restoredTop sz="94694"/>
  </p:normalViewPr>
  <p:slideViewPr>
    <p:cSldViewPr snapToGrid="0" snapToObjects="1">
      <p:cViewPr varScale="1">
        <p:scale>
          <a:sx n="121" d="100"/>
          <a:sy n="121" d="100"/>
        </p:scale>
        <p:origin x="139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microsoft.com/office/2016/11/relationships/changesInfo" Target="changesInfos/changesInfo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ihad Nesrallah" userId="8bde8390f922eb33" providerId="LiveId" clId="{756AFC3C-E2E3-1248-B6E0-249E7406E605}"/>
    <pc:docChg chg="custSel modSld">
      <pc:chgData name="Gihad Nesrallah" userId="8bde8390f922eb33" providerId="LiveId" clId="{756AFC3C-E2E3-1248-B6E0-249E7406E605}" dt="2021-06-26T15:50:37.407" v="40" actId="20577"/>
      <pc:docMkLst>
        <pc:docMk/>
      </pc:docMkLst>
      <pc:sldChg chg="addSp modSp mod">
        <pc:chgData name="Gihad Nesrallah" userId="8bde8390f922eb33" providerId="LiveId" clId="{756AFC3C-E2E3-1248-B6E0-249E7406E605}" dt="2021-06-26T15:49:02.422" v="36" actId="20577"/>
        <pc:sldMkLst>
          <pc:docMk/>
          <pc:sldMk cId="3051435570" sldId="258"/>
        </pc:sldMkLst>
        <pc:spChg chg="add mod">
          <ac:chgData name="Gihad Nesrallah" userId="8bde8390f922eb33" providerId="LiveId" clId="{756AFC3C-E2E3-1248-B6E0-249E7406E605}" dt="2021-06-26T15:49:02.422" v="36" actId="20577"/>
          <ac:spMkLst>
            <pc:docMk/>
            <pc:sldMk cId="3051435570" sldId="258"/>
            <ac:spMk id="5" creationId="{E388AE3E-700C-8740-966B-876364D02326}"/>
          </ac:spMkLst>
        </pc:spChg>
        <pc:spChg chg="mod">
          <ac:chgData name="Gihad Nesrallah" userId="8bde8390f922eb33" providerId="LiveId" clId="{756AFC3C-E2E3-1248-B6E0-249E7406E605}" dt="2021-06-26T15:48:45.690" v="30" actId="1076"/>
          <ac:spMkLst>
            <pc:docMk/>
            <pc:sldMk cId="3051435570" sldId="258"/>
            <ac:spMk id="8" creationId="{DFBC4418-AC4E-824B-9A31-96C32DC12113}"/>
          </ac:spMkLst>
        </pc:spChg>
        <pc:picChg chg="mod">
          <ac:chgData name="Gihad Nesrallah" userId="8bde8390f922eb33" providerId="LiveId" clId="{756AFC3C-E2E3-1248-B6E0-249E7406E605}" dt="2021-06-26T15:48:42.573" v="29" actId="1076"/>
          <ac:picMkLst>
            <pc:docMk/>
            <pc:sldMk cId="3051435570" sldId="258"/>
            <ac:picMk id="2" creationId="{D3990FEC-173E-477A-80FC-A9A77527BCD2}"/>
          </ac:picMkLst>
        </pc:picChg>
        <pc:picChg chg="add mod">
          <ac:chgData name="Gihad Nesrallah" userId="8bde8390f922eb33" providerId="LiveId" clId="{756AFC3C-E2E3-1248-B6E0-249E7406E605}" dt="2021-06-26T15:48:48.851" v="31" actId="1076"/>
          <ac:picMkLst>
            <pc:docMk/>
            <pc:sldMk cId="3051435570" sldId="258"/>
            <ac:picMk id="4" creationId="{40016404-12CC-6442-B9F4-2BF8F51CB148}"/>
          </ac:picMkLst>
        </pc:picChg>
      </pc:sldChg>
      <pc:sldChg chg="delSp mod">
        <pc:chgData name="Gihad Nesrallah" userId="8bde8390f922eb33" providerId="LiveId" clId="{756AFC3C-E2E3-1248-B6E0-249E7406E605}" dt="2021-06-21T21:08:44.236" v="0" actId="478"/>
        <pc:sldMkLst>
          <pc:docMk/>
          <pc:sldMk cId="2291767739" sldId="261"/>
        </pc:sldMkLst>
        <pc:spChg chg="del">
          <ac:chgData name="Gihad Nesrallah" userId="8bde8390f922eb33" providerId="LiveId" clId="{756AFC3C-E2E3-1248-B6E0-249E7406E605}" dt="2021-06-21T21:08:44.236" v="0" actId="478"/>
          <ac:spMkLst>
            <pc:docMk/>
            <pc:sldMk cId="2291767739" sldId="261"/>
            <ac:spMk id="9" creationId="{0BCBFA4A-01FB-46E7-B16D-05B98564AEC6}"/>
          </ac:spMkLst>
        </pc:spChg>
      </pc:sldChg>
      <pc:sldChg chg="modSp mod">
        <pc:chgData name="Gihad Nesrallah" userId="8bde8390f922eb33" providerId="LiveId" clId="{756AFC3C-E2E3-1248-B6E0-249E7406E605}" dt="2021-06-26T15:50:37.407" v="40" actId="20577"/>
        <pc:sldMkLst>
          <pc:docMk/>
          <pc:sldMk cId="2425651998" sldId="277"/>
        </pc:sldMkLst>
        <pc:spChg chg="mod">
          <ac:chgData name="Gihad Nesrallah" userId="8bde8390f922eb33" providerId="LiveId" clId="{756AFC3C-E2E3-1248-B6E0-249E7406E605}" dt="2021-06-26T15:50:37.407" v="40" actId="20577"/>
          <ac:spMkLst>
            <pc:docMk/>
            <pc:sldMk cId="2425651998" sldId="277"/>
            <ac:spMk id="4" creationId="{61734171-A701-DD48-A4FA-630F174A68B7}"/>
          </ac:spMkLst>
        </pc:spChg>
        <pc:picChg chg="mod">
          <ac:chgData name="Gihad Nesrallah" userId="8bde8390f922eb33" providerId="LiveId" clId="{756AFC3C-E2E3-1248-B6E0-249E7406E605}" dt="2021-06-26T15:49:49.658" v="37" actId="1076"/>
          <ac:picMkLst>
            <pc:docMk/>
            <pc:sldMk cId="2425651998" sldId="277"/>
            <ac:picMk id="2" creationId="{F24F067C-E3F8-4045-B1DC-08D114E1B706}"/>
          </ac:picMkLst>
        </pc:picChg>
      </pc:sldChg>
      <pc:sldChg chg="modSp mod">
        <pc:chgData name="Gihad Nesrallah" userId="8bde8390f922eb33" providerId="LiveId" clId="{756AFC3C-E2E3-1248-B6E0-249E7406E605}" dt="2021-06-21T21:19:35.462" v="9" actId="20577"/>
        <pc:sldMkLst>
          <pc:docMk/>
          <pc:sldMk cId="3062482854" sldId="282"/>
        </pc:sldMkLst>
        <pc:spChg chg="mod">
          <ac:chgData name="Gihad Nesrallah" userId="8bde8390f922eb33" providerId="LiveId" clId="{756AFC3C-E2E3-1248-B6E0-249E7406E605}" dt="2021-06-21T21:19:35.462" v="9" actId="20577"/>
          <ac:spMkLst>
            <pc:docMk/>
            <pc:sldMk cId="3062482854" sldId="282"/>
            <ac:spMk id="4" creationId="{61734171-A701-DD48-A4FA-630F174A68B7}"/>
          </ac:spMkLst>
        </pc:spChg>
      </pc:sldChg>
      <pc:sldChg chg="modSp mod">
        <pc:chgData name="Gihad Nesrallah" userId="8bde8390f922eb33" providerId="LiveId" clId="{756AFC3C-E2E3-1248-B6E0-249E7406E605}" dt="2021-06-21T21:19:49.311" v="26" actId="20577"/>
        <pc:sldMkLst>
          <pc:docMk/>
          <pc:sldMk cId="2580570343" sldId="283"/>
        </pc:sldMkLst>
        <pc:spChg chg="mod">
          <ac:chgData name="Gihad Nesrallah" userId="8bde8390f922eb33" providerId="LiveId" clId="{756AFC3C-E2E3-1248-B6E0-249E7406E605}" dt="2021-06-21T21:19:49.311" v="26" actId="20577"/>
          <ac:spMkLst>
            <pc:docMk/>
            <pc:sldMk cId="2580570343" sldId="283"/>
            <ac:spMk id="4" creationId="{61734171-A701-DD48-A4FA-630F174A68B7}"/>
          </ac:spMkLst>
        </pc:spChg>
      </pc:sldChg>
    </pc:docChg>
  </pc:docChgLst>
  <pc:docChgLst>
    <pc:chgData name="maryam kandi" userId="3dae5b15da3a7b39" providerId="Windows Live" clId="Web-{4D7AB1A2-73F0-4374-A5AF-B96C6BF3A8B1}"/>
    <pc:docChg chg="addSld delSld modSld sldOrd addMainMaster delMainMaster">
      <pc:chgData name="maryam kandi" userId="3dae5b15da3a7b39" providerId="Windows Live" clId="Web-{4D7AB1A2-73F0-4374-A5AF-B96C6BF3A8B1}" dt="2021-04-20T17:35:18.083" v="412" actId="20577"/>
      <pc:docMkLst>
        <pc:docMk/>
      </pc:docMkLst>
      <pc:sldChg chg="addSp delSp modSp mod modClrScheme modShow chgLayout">
        <pc:chgData name="maryam kandi" userId="3dae5b15da3a7b39" providerId="Windows Live" clId="Web-{4D7AB1A2-73F0-4374-A5AF-B96C6BF3A8B1}" dt="2021-04-20T16:19:07.345" v="360" actId="14100"/>
        <pc:sldMkLst>
          <pc:docMk/>
          <pc:sldMk cId="1414725883" sldId="256"/>
        </pc:sldMkLst>
        <pc:spChg chg="mod ord">
          <ac:chgData name="maryam kandi" userId="3dae5b15da3a7b39" providerId="Windows Live" clId="Web-{4D7AB1A2-73F0-4374-A5AF-B96C6BF3A8B1}" dt="2021-04-20T16:18:35.658" v="354" actId="20577"/>
          <ac:spMkLst>
            <pc:docMk/>
            <pc:sldMk cId="1414725883" sldId="256"/>
            <ac:spMk id="4" creationId="{61734171-A701-DD48-A4FA-630F174A68B7}"/>
          </ac:spMkLst>
        </pc:spChg>
        <pc:spChg chg="mod">
          <ac:chgData name="maryam kandi" userId="3dae5b15da3a7b39" providerId="Windows Live" clId="Web-{4D7AB1A2-73F0-4374-A5AF-B96C6BF3A8B1}" dt="2021-04-20T16:18:46.361" v="358" actId="20577"/>
          <ac:spMkLst>
            <pc:docMk/>
            <pc:sldMk cId="1414725883" sldId="256"/>
            <ac:spMk id="9" creationId="{785FF1E0-1A5E-E44F-86A1-154B7B4A4149}"/>
          </ac:spMkLst>
        </pc:spChg>
        <pc:picChg chg="add mod">
          <ac:chgData name="maryam kandi" userId="3dae5b15da3a7b39" providerId="Windows Live" clId="Web-{4D7AB1A2-73F0-4374-A5AF-B96C6BF3A8B1}" dt="2021-04-20T16:19:07.345" v="360" actId="14100"/>
          <ac:picMkLst>
            <pc:docMk/>
            <pc:sldMk cId="1414725883" sldId="256"/>
            <ac:picMk id="2" creationId="{F3FA17EA-69C8-46B8-A6B3-F42A2DDD007D}"/>
          </ac:picMkLst>
        </pc:picChg>
        <pc:picChg chg="add mod">
          <ac:chgData name="maryam kandi" userId="3dae5b15da3a7b39" providerId="Windows Live" clId="Web-{4D7AB1A2-73F0-4374-A5AF-B96C6BF3A8B1}" dt="2021-04-20T16:18:52.799" v="359" actId="14100"/>
          <ac:picMkLst>
            <pc:docMk/>
            <pc:sldMk cId="1414725883" sldId="256"/>
            <ac:picMk id="3" creationId="{3CDD7378-3C54-405F-8627-0916966E4D8D}"/>
          </ac:picMkLst>
        </pc:picChg>
        <pc:picChg chg="del">
          <ac:chgData name="maryam kandi" userId="3dae5b15da3a7b39" providerId="Windows Live" clId="Web-{4D7AB1A2-73F0-4374-A5AF-B96C6BF3A8B1}" dt="2021-04-20T08:20:44.145" v="2"/>
          <ac:picMkLst>
            <pc:docMk/>
            <pc:sldMk cId="1414725883" sldId="256"/>
            <ac:picMk id="6" creationId="{A84E032D-92D1-4957-988C-442F7E4276BF}"/>
          </ac:picMkLst>
        </pc:picChg>
        <pc:picChg chg="del">
          <ac:chgData name="maryam kandi" userId="3dae5b15da3a7b39" providerId="Windows Live" clId="Web-{4D7AB1A2-73F0-4374-A5AF-B96C6BF3A8B1}" dt="2021-04-20T08:21:31.379" v="9"/>
          <ac:picMkLst>
            <pc:docMk/>
            <pc:sldMk cId="1414725883" sldId="256"/>
            <ac:picMk id="8" creationId="{A8469CBC-7BB6-4234-9A38-544432743156}"/>
          </ac:picMkLst>
        </pc:picChg>
      </pc:sldChg>
      <pc:sldChg chg="addSp delSp modSp mod modClrScheme chgLayout">
        <pc:chgData name="maryam kandi" userId="3dae5b15da3a7b39" providerId="Windows Live" clId="Web-{4D7AB1A2-73F0-4374-A5AF-B96C6BF3A8B1}" dt="2021-04-20T16:17:41.595" v="348" actId="20577"/>
        <pc:sldMkLst>
          <pc:docMk/>
          <pc:sldMk cId="3051435570" sldId="258"/>
        </pc:sldMkLst>
        <pc:spChg chg="del mod">
          <ac:chgData name="maryam kandi" userId="3dae5b15da3a7b39" providerId="Windows Live" clId="Web-{4D7AB1A2-73F0-4374-A5AF-B96C6BF3A8B1}" dt="2021-04-20T16:16:44.158" v="341"/>
          <ac:spMkLst>
            <pc:docMk/>
            <pc:sldMk cId="3051435570" sldId="258"/>
            <ac:spMk id="6" creationId="{32ED9215-E038-B64A-89B3-CFD54CD1DC05}"/>
          </ac:spMkLst>
        </pc:spChg>
        <pc:spChg chg="mod">
          <ac:chgData name="maryam kandi" userId="3dae5b15da3a7b39" providerId="Windows Live" clId="Web-{4D7AB1A2-73F0-4374-A5AF-B96C6BF3A8B1}" dt="2021-04-20T16:17:41.595" v="348" actId="20577"/>
          <ac:spMkLst>
            <pc:docMk/>
            <pc:sldMk cId="3051435570" sldId="258"/>
            <ac:spMk id="8" creationId="{DFBC4418-AC4E-824B-9A31-96C32DC12113}"/>
          </ac:spMkLst>
        </pc:spChg>
        <pc:picChg chg="add mod">
          <ac:chgData name="maryam kandi" userId="3dae5b15da3a7b39" providerId="Windows Live" clId="Web-{4D7AB1A2-73F0-4374-A5AF-B96C6BF3A8B1}" dt="2021-04-20T16:17:09.642" v="346" actId="14100"/>
          <ac:picMkLst>
            <pc:docMk/>
            <pc:sldMk cId="3051435570" sldId="258"/>
            <ac:picMk id="2" creationId="{D3990FEC-173E-477A-80FC-A9A77527BCD2}"/>
          </ac:picMkLst>
        </pc:picChg>
        <pc:picChg chg="add del mod">
          <ac:chgData name="maryam kandi" userId="3dae5b15da3a7b39" providerId="Windows Live" clId="Web-{4D7AB1A2-73F0-4374-A5AF-B96C6BF3A8B1}" dt="2021-04-20T16:16:47.845" v="342"/>
          <ac:picMkLst>
            <pc:docMk/>
            <pc:sldMk cId="3051435570" sldId="258"/>
            <ac:picMk id="3" creationId="{D8492D62-FFA9-42DD-9E30-8550ADD51C47}"/>
          </ac:picMkLst>
        </pc:picChg>
        <pc:picChg chg="add del">
          <ac:chgData name="maryam kandi" userId="3dae5b15da3a7b39" providerId="Windows Live" clId="Web-{4D7AB1A2-73F0-4374-A5AF-B96C6BF3A8B1}" dt="2021-04-20T08:24:25.510" v="20"/>
          <ac:picMkLst>
            <pc:docMk/>
            <pc:sldMk cId="3051435570" sldId="258"/>
            <ac:picMk id="4" creationId="{C38C7EF2-5DA3-4981-9F5B-D65145D199C6}"/>
          </ac:picMkLst>
        </pc:picChg>
        <pc:picChg chg="del">
          <ac:chgData name="maryam kandi" userId="3dae5b15da3a7b39" providerId="Windows Live" clId="Web-{4D7AB1A2-73F0-4374-A5AF-B96C6BF3A8B1}" dt="2021-04-20T08:27:17.774" v="26"/>
          <ac:picMkLst>
            <pc:docMk/>
            <pc:sldMk cId="3051435570" sldId="258"/>
            <ac:picMk id="7" creationId="{40016404-12CC-6442-B9F4-2BF8F51CB148}"/>
          </ac:picMkLst>
        </pc:picChg>
      </pc:sldChg>
      <pc:sldChg chg="addSp delSp modSp mod modClrScheme chgLayout">
        <pc:chgData name="maryam kandi" userId="3dae5b15da3a7b39" providerId="Windows Live" clId="Web-{4D7AB1A2-73F0-4374-A5AF-B96C6BF3A8B1}" dt="2021-04-20T16:20:11.799" v="361" actId="20577"/>
        <pc:sldMkLst>
          <pc:docMk/>
          <pc:sldMk cId="1018678779" sldId="259"/>
        </pc:sldMkLst>
        <pc:spChg chg="mod ord">
          <ac:chgData name="maryam kandi" userId="3dae5b15da3a7b39" providerId="Windows Live" clId="Web-{4D7AB1A2-73F0-4374-A5AF-B96C6BF3A8B1}" dt="2021-04-20T16:20:11.799" v="361" actId="20577"/>
          <ac:spMkLst>
            <pc:docMk/>
            <pc:sldMk cId="1018678779" sldId="259"/>
            <ac:spMk id="4" creationId="{61734171-A701-DD48-A4FA-630F174A68B7}"/>
          </ac:spMkLst>
        </pc:spChg>
        <pc:picChg chg="add del mod">
          <ac:chgData name="maryam kandi" userId="3dae5b15da3a7b39" providerId="Windows Live" clId="Web-{4D7AB1A2-73F0-4374-A5AF-B96C6BF3A8B1}" dt="2021-04-20T08:29:32.828" v="33"/>
          <ac:picMkLst>
            <pc:docMk/>
            <pc:sldMk cId="1018678779" sldId="259"/>
            <ac:picMk id="2" creationId="{48480827-560E-4C2C-85A8-7DFA0FE4A851}"/>
          </ac:picMkLst>
        </pc:picChg>
        <pc:picChg chg="add del mod">
          <ac:chgData name="maryam kandi" userId="3dae5b15da3a7b39" providerId="Windows Live" clId="Web-{4D7AB1A2-73F0-4374-A5AF-B96C6BF3A8B1}" dt="2021-04-20T08:29:56.313" v="36" actId="1076"/>
          <ac:picMkLst>
            <pc:docMk/>
            <pc:sldMk cId="1018678779" sldId="259"/>
            <ac:picMk id="5" creationId="{F3CB545A-7855-46B0-ACE8-FE8A68E07543}"/>
          </ac:picMkLst>
        </pc:picChg>
      </pc:sldChg>
      <pc:sldChg chg="addSp delSp modSp mod modClrScheme chgLayout">
        <pc:chgData name="maryam kandi" userId="3dae5b15da3a7b39" providerId="Windows Live" clId="Web-{4D7AB1A2-73F0-4374-A5AF-B96C6BF3A8B1}" dt="2021-04-20T15:55:36.013" v="269" actId="14100"/>
        <pc:sldMkLst>
          <pc:docMk/>
          <pc:sldMk cId="3360400957" sldId="260"/>
        </pc:sldMkLst>
        <pc:spChg chg="mod ord">
          <ac:chgData name="maryam kandi" userId="3dae5b15da3a7b39" providerId="Windows Live" clId="Web-{4D7AB1A2-73F0-4374-A5AF-B96C6BF3A8B1}" dt="2021-04-20T15:47:00.434" v="243"/>
          <ac:spMkLst>
            <pc:docMk/>
            <pc:sldMk cId="3360400957" sldId="260"/>
            <ac:spMk id="4" creationId="{61734171-A701-DD48-A4FA-630F174A68B7}"/>
          </ac:spMkLst>
        </pc:spChg>
        <pc:picChg chg="add mod">
          <ac:chgData name="maryam kandi" userId="3dae5b15da3a7b39" providerId="Windows Live" clId="Web-{4D7AB1A2-73F0-4374-A5AF-B96C6BF3A8B1}" dt="2021-04-20T15:55:36.013" v="269" actId="14100"/>
          <ac:picMkLst>
            <pc:docMk/>
            <pc:sldMk cId="3360400957" sldId="260"/>
            <ac:picMk id="2" creationId="{019E210D-FDDC-4571-B01C-34BB7EA6CC19}"/>
          </ac:picMkLst>
        </pc:picChg>
        <pc:picChg chg="del">
          <ac:chgData name="maryam kandi" userId="3dae5b15da3a7b39" providerId="Windows Live" clId="Web-{4D7AB1A2-73F0-4374-A5AF-B96C6BF3A8B1}" dt="2021-04-20T08:34:42.892" v="41"/>
          <ac:picMkLst>
            <pc:docMk/>
            <pc:sldMk cId="3360400957" sldId="260"/>
            <ac:picMk id="6" creationId="{C9F07AB0-97FD-1A45-8658-907F320E807B}"/>
          </ac:picMkLst>
        </pc:picChg>
      </pc:sldChg>
      <pc:sldChg chg="addSp delSp modSp mod modClrScheme chgLayout">
        <pc:chgData name="maryam kandi" userId="3dae5b15da3a7b39" providerId="Windows Live" clId="Web-{4D7AB1A2-73F0-4374-A5AF-B96C6BF3A8B1}" dt="2021-04-20T17:27:17.446" v="393" actId="20577"/>
        <pc:sldMkLst>
          <pc:docMk/>
          <pc:sldMk cId="2291767739" sldId="261"/>
        </pc:sldMkLst>
        <pc:spChg chg="add del mod ord">
          <ac:chgData name="maryam kandi" userId="3dae5b15da3a7b39" providerId="Windows Live" clId="Web-{4D7AB1A2-73F0-4374-A5AF-B96C6BF3A8B1}" dt="2021-04-20T17:26:56.134" v="389"/>
          <ac:spMkLst>
            <pc:docMk/>
            <pc:sldMk cId="2291767739" sldId="261"/>
            <ac:spMk id="4" creationId="{61734171-A701-DD48-A4FA-630F174A68B7}"/>
          </ac:spMkLst>
        </pc:spChg>
        <pc:spChg chg="add del mod">
          <ac:chgData name="maryam kandi" userId="3dae5b15da3a7b39" providerId="Windows Live" clId="Web-{4D7AB1A2-73F0-4374-A5AF-B96C6BF3A8B1}" dt="2021-04-20T17:23:20.198" v="385"/>
          <ac:spMkLst>
            <pc:docMk/>
            <pc:sldMk cId="2291767739" sldId="261"/>
            <ac:spMk id="6" creationId="{8AFF51B8-932E-47EC-9133-6B71C3D188D9}"/>
          </ac:spMkLst>
        </pc:spChg>
        <pc:spChg chg="mod">
          <ac:chgData name="maryam kandi" userId="3dae5b15da3a7b39" providerId="Windows Live" clId="Web-{4D7AB1A2-73F0-4374-A5AF-B96C6BF3A8B1}" dt="2021-04-20T17:27:17.446" v="393" actId="20577"/>
          <ac:spMkLst>
            <pc:docMk/>
            <pc:sldMk cId="2291767739" sldId="261"/>
            <ac:spMk id="7" creationId="{2BA466B8-1321-AE4B-A475-D11804BC1F80}"/>
          </ac:spMkLst>
        </pc:spChg>
        <pc:spChg chg="add mod">
          <ac:chgData name="maryam kandi" userId="3dae5b15da3a7b39" providerId="Windows Live" clId="Web-{4D7AB1A2-73F0-4374-A5AF-B96C6BF3A8B1}" dt="2021-04-20T17:26:56.134" v="389"/>
          <ac:spMkLst>
            <pc:docMk/>
            <pc:sldMk cId="2291767739" sldId="261"/>
            <ac:spMk id="9" creationId="{0BCBFA4A-01FB-46E7-B16D-05B98564AEC6}"/>
          </ac:spMkLst>
        </pc:spChg>
        <pc:picChg chg="add del mod">
          <ac:chgData name="maryam kandi" userId="3dae5b15da3a7b39" providerId="Windows Live" clId="Web-{4D7AB1A2-73F0-4374-A5AF-B96C6BF3A8B1}" dt="2021-04-20T17:26:50.774" v="387"/>
          <ac:picMkLst>
            <pc:docMk/>
            <pc:sldMk cId="2291767739" sldId="261"/>
            <ac:picMk id="2" creationId="{8B3E0230-58D0-4548-98DE-0D832208ADEB}"/>
          </ac:picMkLst>
        </pc:picChg>
        <pc:picChg chg="add mod">
          <ac:chgData name="maryam kandi" userId="3dae5b15da3a7b39" providerId="Windows Live" clId="Web-{4D7AB1A2-73F0-4374-A5AF-B96C6BF3A8B1}" dt="2021-04-20T17:27:06.634" v="391" actId="1076"/>
          <ac:picMkLst>
            <pc:docMk/>
            <pc:sldMk cId="2291767739" sldId="261"/>
            <ac:picMk id="3" creationId="{7D949A4D-652C-4280-B6FB-30D9450CA85C}"/>
          </ac:picMkLst>
        </pc:picChg>
        <pc:picChg chg="del">
          <ac:chgData name="maryam kandi" userId="3dae5b15da3a7b39" providerId="Windows Live" clId="Web-{4D7AB1A2-73F0-4374-A5AF-B96C6BF3A8B1}" dt="2021-04-20T08:40:22.107" v="69"/>
          <ac:picMkLst>
            <pc:docMk/>
            <pc:sldMk cId="2291767739" sldId="261"/>
            <ac:picMk id="6" creationId="{9A8A1682-18E0-E840-8B54-36C2672B1B67}"/>
          </ac:picMkLst>
        </pc:picChg>
        <pc:picChg chg="del">
          <ac:chgData name="maryam kandi" userId="3dae5b15da3a7b39" providerId="Windows Live" clId="Web-{4D7AB1A2-73F0-4374-A5AF-B96C6BF3A8B1}" dt="2021-04-20T08:41:09.061" v="75"/>
          <ac:picMkLst>
            <pc:docMk/>
            <pc:sldMk cId="2291767739" sldId="261"/>
            <ac:picMk id="8" creationId="{B5179650-16F7-7141-9BB1-F2248CC56B10}"/>
          </ac:picMkLst>
        </pc:picChg>
      </pc:sldChg>
      <pc:sldChg chg="del">
        <pc:chgData name="maryam kandi" userId="3dae5b15da3a7b39" providerId="Windows Live" clId="Web-{4D7AB1A2-73F0-4374-A5AF-B96C6BF3A8B1}" dt="2021-04-20T15:44:14.449" v="220"/>
        <pc:sldMkLst>
          <pc:docMk/>
          <pc:sldMk cId="2746427903" sldId="262"/>
        </pc:sldMkLst>
      </pc:sldChg>
      <pc:sldChg chg="del">
        <pc:chgData name="maryam kandi" userId="3dae5b15da3a7b39" providerId="Windows Live" clId="Web-{4D7AB1A2-73F0-4374-A5AF-B96C6BF3A8B1}" dt="2021-04-20T15:44:14.449" v="219"/>
        <pc:sldMkLst>
          <pc:docMk/>
          <pc:sldMk cId="2571048664" sldId="263"/>
        </pc:sldMkLst>
      </pc:sldChg>
      <pc:sldChg chg="addSp delSp modSp mod modClrScheme chgLayout">
        <pc:chgData name="maryam kandi" userId="3dae5b15da3a7b39" providerId="Windows Live" clId="Web-{4D7AB1A2-73F0-4374-A5AF-B96C6BF3A8B1}" dt="2021-04-20T17:29:40.523" v="404" actId="14100"/>
        <pc:sldMkLst>
          <pc:docMk/>
          <pc:sldMk cId="1841772963" sldId="264"/>
        </pc:sldMkLst>
        <pc:spChg chg="add del mod">
          <ac:chgData name="maryam kandi" userId="3dae5b15da3a7b39" providerId="Windows Live" clId="Web-{4D7AB1A2-73F0-4374-A5AF-B96C6BF3A8B1}" dt="2021-04-20T17:27:34.696" v="394"/>
          <ac:spMkLst>
            <pc:docMk/>
            <pc:sldMk cId="1841772963" sldId="264"/>
            <ac:spMk id="4" creationId="{D8713651-F972-E44A-8921-6616912E36DD}"/>
          </ac:spMkLst>
        </pc:spChg>
        <pc:spChg chg="mod">
          <ac:chgData name="maryam kandi" userId="3dae5b15da3a7b39" providerId="Windows Live" clId="Web-{4D7AB1A2-73F0-4374-A5AF-B96C6BF3A8B1}" dt="2021-04-20T17:28:06.930" v="398" actId="20577"/>
          <ac:spMkLst>
            <pc:docMk/>
            <pc:sldMk cId="1841772963" sldId="264"/>
            <ac:spMk id="7" creationId="{2BA466B8-1321-AE4B-A475-D11804BC1F80}"/>
          </ac:spMkLst>
        </pc:spChg>
        <pc:picChg chg="add del mod">
          <ac:chgData name="maryam kandi" userId="3dae5b15da3a7b39" providerId="Windows Live" clId="Web-{4D7AB1A2-73F0-4374-A5AF-B96C6BF3A8B1}" dt="2021-04-20T17:27:36.993" v="395"/>
          <ac:picMkLst>
            <pc:docMk/>
            <pc:sldMk cId="1841772963" sldId="264"/>
            <ac:picMk id="2" creationId="{B76F09DF-5120-422E-95C1-A2B0A33D63DE}"/>
          </ac:picMkLst>
        </pc:picChg>
        <pc:picChg chg="add del mod">
          <ac:chgData name="maryam kandi" userId="3dae5b15da3a7b39" providerId="Windows Live" clId="Web-{4D7AB1A2-73F0-4374-A5AF-B96C6BF3A8B1}" dt="2021-04-20T17:29:00.570" v="399"/>
          <ac:picMkLst>
            <pc:docMk/>
            <pc:sldMk cId="1841772963" sldId="264"/>
            <ac:picMk id="3" creationId="{C077E209-C9A7-409B-905F-797E116E2EC6}"/>
          </ac:picMkLst>
        </pc:picChg>
        <pc:picChg chg="add mod">
          <ac:chgData name="maryam kandi" userId="3dae5b15da3a7b39" providerId="Windows Live" clId="Web-{4D7AB1A2-73F0-4374-A5AF-B96C6BF3A8B1}" dt="2021-04-20T17:29:40.523" v="404" actId="14100"/>
          <ac:picMkLst>
            <pc:docMk/>
            <pc:sldMk cId="1841772963" sldId="264"/>
            <ac:picMk id="5" creationId="{826D2EC0-DB5D-4068-829B-9EE4E392F272}"/>
          </ac:picMkLst>
        </pc:picChg>
        <pc:picChg chg="del">
          <ac:chgData name="maryam kandi" userId="3dae5b15da3a7b39" providerId="Windows Live" clId="Web-{4D7AB1A2-73F0-4374-A5AF-B96C6BF3A8B1}" dt="2021-04-20T08:42:15.357" v="84"/>
          <ac:picMkLst>
            <pc:docMk/>
            <pc:sldMk cId="1841772963" sldId="264"/>
            <ac:picMk id="8" creationId="{5718022E-2A8D-4F99-AAB3-8CF41A25ABB2}"/>
          </ac:picMkLst>
        </pc:picChg>
        <pc:picChg chg="del">
          <ac:chgData name="maryam kandi" userId="3dae5b15da3a7b39" providerId="Windows Live" clId="Web-{4D7AB1A2-73F0-4374-A5AF-B96C6BF3A8B1}" dt="2021-04-20T08:43:02.671" v="90"/>
          <ac:picMkLst>
            <pc:docMk/>
            <pc:sldMk cId="1841772963" sldId="264"/>
            <ac:picMk id="9" creationId="{509B3A4E-8C56-154C-BE78-F78FD2A8E8FE}"/>
          </ac:picMkLst>
        </pc:picChg>
      </pc:sldChg>
      <pc:sldChg chg="addSp delSp modSp mod modClrScheme chgLayout">
        <pc:chgData name="maryam kandi" userId="3dae5b15da3a7b39" providerId="Windows Live" clId="Web-{4D7AB1A2-73F0-4374-A5AF-B96C6BF3A8B1}" dt="2021-04-20T15:47:00.434" v="243"/>
        <pc:sldMkLst>
          <pc:docMk/>
          <pc:sldMk cId="2965136875" sldId="265"/>
        </pc:sldMkLst>
        <pc:spChg chg="del mod">
          <ac:chgData name="maryam kandi" userId="3dae5b15da3a7b39" providerId="Windows Live" clId="Web-{4D7AB1A2-73F0-4374-A5AF-B96C6BF3A8B1}" dt="2021-04-20T10:17:22.077" v="105"/>
          <ac:spMkLst>
            <pc:docMk/>
            <pc:sldMk cId="2965136875" sldId="265"/>
            <ac:spMk id="4" creationId="{D8713651-F972-E44A-8921-6616912E36DD}"/>
          </ac:spMkLst>
        </pc:spChg>
        <pc:spChg chg="mod">
          <ac:chgData name="maryam kandi" userId="3dae5b15da3a7b39" providerId="Windows Live" clId="Web-{4D7AB1A2-73F0-4374-A5AF-B96C6BF3A8B1}" dt="2021-04-20T10:18:37.123" v="112" actId="20577"/>
          <ac:spMkLst>
            <pc:docMk/>
            <pc:sldMk cId="2965136875" sldId="265"/>
            <ac:spMk id="7" creationId="{2BA466B8-1321-AE4B-A475-D11804BC1F80}"/>
          </ac:spMkLst>
        </pc:spChg>
        <pc:picChg chg="add mod">
          <ac:chgData name="maryam kandi" userId="3dae5b15da3a7b39" providerId="Windows Live" clId="Web-{4D7AB1A2-73F0-4374-A5AF-B96C6BF3A8B1}" dt="2021-04-20T10:17:30.546" v="109" actId="1076"/>
          <ac:picMkLst>
            <pc:docMk/>
            <pc:sldMk cId="2965136875" sldId="265"/>
            <ac:picMk id="2" creationId="{03661128-11A0-40C9-9D8E-6557EB54581D}"/>
          </ac:picMkLst>
        </pc:picChg>
        <pc:picChg chg="del">
          <ac:chgData name="maryam kandi" userId="3dae5b15da3a7b39" providerId="Windows Live" clId="Web-{4D7AB1A2-73F0-4374-A5AF-B96C6BF3A8B1}" dt="2021-04-20T10:17:24.593" v="106"/>
          <ac:picMkLst>
            <pc:docMk/>
            <pc:sldMk cId="2965136875" sldId="265"/>
            <ac:picMk id="6" creationId="{3870F5D5-8D95-4727-A849-B4D204CEC692}"/>
          </ac:picMkLst>
        </pc:picChg>
        <pc:picChg chg="del">
          <ac:chgData name="maryam kandi" userId="3dae5b15da3a7b39" providerId="Windows Live" clId="Web-{4D7AB1A2-73F0-4374-A5AF-B96C6BF3A8B1}" dt="2021-04-20T08:44:27.576" v="97"/>
          <ac:picMkLst>
            <pc:docMk/>
            <pc:sldMk cId="2965136875" sldId="265"/>
            <ac:picMk id="8" creationId="{57985E71-2B82-4EBC-B503-81936D4C997D}"/>
          </ac:picMkLst>
        </pc:picChg>
      </pc:sldChg>
      <pc:sldChg chg="del">
        <pc:chgData name="maryam kandi" userId="3dae5b15da3a7b39" providerId="Windows Live" clId="Web-{4D7AB1A2-73F0-4374-A5AF-B96C6BF3A8B1}" dt="2021-04-20T10:20:41.355" v="145"/>
        <pc:sldMkLst>
          <pc:docMk/>
          <pc:sldMk cId="3700705647" sldId="266"/>
        </pc:sldMkLst>
      </pc:sldChg>
      <pc:sldChg chg="del">
        <pc:chgData name="maryam kandi" userId="3dae5b15da3a7b39" providerId="Windows Live" clId="Web-{4D7AB1A2-73F0-4374-A5AF-B96C6BF3A8B1}" dt="2021-04-20T10:26:39.146" v="185"/>
        <pc:sldMkLst>
          <pc:docMk/>
          <pc:sldMk cId="1654172752" sldId="267"/>
        </pc:sldMkLst>
      </pc:sldChg>
      <pc:sldChg chg="del">
        <pc:chgData name="maryam kandi" userId="3dae5b15da3a7b39" providerId="Windows Live" clId="Web-{4D7AB1A2-73F0-4374-A5AF-B96C6BF3A8B1}" dt="2021-04-20T15:44:14.465" v="222"/>
        <pc:sldMkLst>
          <pc:docMk/>
          <pc:sldMk cId="1833588595" sldId="268"/>
        </pc:sldMkLst>
      </pc:sldChg>
      <pc:sldChg chg="del">
        <pc:chgData name="maryam kandi" userId="3dae5b15da3a7b39" providerId="Windows Live" clId="Web-{4D7AB1A2-73F0-4374-A5AF-B96C6BF3A8B1}" dt="2021-04-20T15:44:14.465" v="223"/>
        <pc:sldMkLst>
          <pc:docMk/>
          <pc:sldMk cId="4289238314" sldId="270"/>
        </pc:sldMkLst>
      </pc:sldChg>
      <pc:sldChg chg="del">
        <pc:chgData name="maryam kandi" userId="3dae5b15da3a7b39" providerId="Windows Live" clId="Web-{4D7AB1A2-73F0-4374-A5AF-B96C6BF3A8B1}" dt="2021-04-20T15:44:14.449" v="221"/>
        <pc:sldMkLst>
          <pc:docMk/>
          <pc:sldMk cId="486323148" sldId="271"/>
        </pc:sldMkLst>
      </pc:sldChg>
      <pc:sldChg chg="del">
        <pc:chgData name="maryam kandi" userId="3dae5b15da3a7b39" providerId="Windows Live" clId="Web-{4D7AB1A2-73F0-4374-A5AF-B96C6BF3A8B1}" dt="2021-04-20T15:44:14.449" v="218"/>
        <pc:sldMkLst>
          <pc:docMk/>
          <pc:sldMk cId="4012310716" sldId="272"/>
        </pc:sldMkLst>
      </pc:sldChg>
      <pc:sldChg chg="del">
        <pc:chgData name="maryam kandi" userId="3dae5b15da3a7b39" providerId="Windows Live" clId="Web-{4D7AB1A2-73F0-4374-A5AF-B96C6BF3A8B1}" dt="2021-04-20T15:44:14.449" v="217"/>
        <pc:sldMkLst>
          <pc:docMk/>
          <pc:sldMk cId="3091903126" sldId="273"/>
        </pc:sldMkLst>
      </pc:sldChg>
      <pc:sldChg chg="del">
        <pc:chgData name="maryam kandi" userId="3dae5b15da3a7b39" providerId="Windows Live" clId="Web-{4D7AB1A2-73F0-4374-A5AF-B96C6BF3A8B1}" dt="2021-04-20T15:44:14.449" v="216"/>
        <pc:sldMkLst>
          <pc:docMk/>
          <pc:sldMk cId="3167622428" sldId="274"/>
        </pc:sldMkLst>
      </pc:sldChg>
      <pc:sldChg chg="del">
        <pc:chgData name="maryam kandi" userId="3dae5b15da3a7b39" providerId="Windows Live" clId="Web-{4D7AB1A2-73F0-4374-A5AF-B96C6BF3A8B1}" dt="2021-04-20T15:44:14.449" v="215"/>
        <pc:sldMkLst>
          <pc:docMk/>
          <pc:sldMk cId="2995286182" sldId="275"/>
        </pc:sldMkLst>
      </pc:sldChg>
      <pc:sldChg chg="del">
        <pc:chgData name="maryam kandi" userId="3dae5b15da3a7b39" providerId="Windows Live" clId="Web-{4D7AB1A2-73F0-4374-A5AF-B96C6BF3A8B1}" dt="2021-04-20T15:44:14.449" v="214"/>
        <pc:sldMkLst>
          <pc:docMk/>
          <pc:sldMk cId="2264128294" sldId="276"/>
        </pc:sldMkLst>
      </pc:sldChg>
      <pc:sldChg chg="addSp delSp modSp add mod replId modClrScheme chgLayout">
        <pc:chgData name="maryam kandi" userId="3dae5b15da3a7b39" providerId="Windows Live" clId="Web-{4D7AB1A2-73F0-4374-A5AF-B96C6BF3A8B1}" dt="2021-04-20T15:55:24.857" v="267" actId="14100"/>
        <pc:sldMkLst>
          <pc:docMk/>
          <pc:sldMk cId="2425651998" sldId="277"/>
        </pc:sldMkLst>
        <pc:spChg chg="mod ord">
          <ac:chgData name="maryam kandi" userId="3dae5b15da3a7b39" providerId="Windows Live" clId="Web-{4D7AB1A2-73F0-4374-A5AF-B96C6BF3A8B1}" dt="2021-04-20T15:47:00.434" v="243"/>
          <ac:spMkLst>
            <pc:docMk/>
            <pc:sldMk cId="2425651998" sldId="277"/>
            <ac:spMk id="4" creationId="{61734171-A701-DD48-A4FA-630F174A68B7}"/>
          </ac:spMkLst>
        </pc:spChg>
        <pc:picChg chg="add mod">
          <ac:chgData name="maryam kandi" userId="3dae5b15da3a7b39" providerId="Windows Live" clId="Web-{4D7AB1A2-73F0-4374-A5AF-B96C6BF3A8B1}" dt="2021-04-20T15:55:24.857" v="267" actId="14100"/>
          <ac:picMkLst>
            <pc:docMk/>
            <pc:sldMk cId="2425651998" sldId="277"/>
            <ac:picMk id="2" creationId="{F24F067C-E3F8-4045-B1DC-08D114E1B706}"/>
          </ac:picMkLst>
        </pc:picChg>
        <pc:picChg chg="del mod">
          <ac:chgData name="maryam kandi" userId="3dae5b15da3a7b39" providerId="Windows Live" clId="Web-{4D7AB1A2-73F0-4374-A5AF-B96C6BF3A8B1}" dt="2021-04-20T08:38:19.812" v="56"/>
          <ac:picMkLst>
            <pc:docMk/>
            <pc:sldMk cId="2425651998" sldId="277"/>
            <ac:picMk id="6" creationId="{C9F07AB0-97FD-1A45-8658-907F320E807B}"/>
          </ac:picMkLst>
        </pc:picChg>
      </pc:sldChg>
      <pc:sldChg chg="addSp delSp modSp add mod ord replId modClrScheme chgLayout">
        <pc:chgData name="maryam kandi" userId="3dae5b15da3a7b39" providerId="Windows Live" clId="Web-{4D7AB1A2-73F0-4374-A5AF-B96C6BF3A8B1}" dt="2021-04-20T17:31:33.475" v="411" actId="20577"/>
        <pc:sldMkLst>
          <pc:docMk/>
          <pc:sldMk cId="4227326657" sldId="278"/>
        </pc:sldMkLst>
        <pc:spChg chg="mod">
          <ac:chgData name="maryam kandi" userId="3dae5b15da3a7b39" providerId="Windows Live" clId="Web-{4D7AB1A2-73F0-4374-A5AF-B96C6BF3A8B1}" dt="2021-04-20T17:30:48.210" v="407" actId="1076"/>
          <ac:spMkLst>
            <pc:docMk/>
            <pc:sldMk cId="4227326657" sldId="278"/>
            <ac:spMk id="4" creationId="{D8713651-F972-E44A-8921-6616912E36DD}"/>
          </ac:spMkLst>
        </pc:spChg>
        <pc:spChg chg="mod">
          <ac:chgData name="maryam kandi" userId="3dae5b15da3a7b39" providerId="Windows Live" clId="Web-{4D7AB1A2-73F0-4374-A5AF-B96C6BF3A8B1}" dt="2021-04-20T17:31:33.475" v="411" actId="20577"/>
          <ac:spMkLst>
            <pc:docMk/>
            <pc:sldMk cId="4227326657" sldId="278"/>
            <ac:spMk id="7" creationId="{2BA466B8-1321-AE4B-A475-D11804BC1F80}"/>
          </ac:spMkLst>
        </pc:spChg>
        <pc:picChg chg="del">
          <ac:chgData name="maryam kandi" userId="3dae5b15da3a7b39" providerId="Windows Live" clId="Web-{4D7AB1A2-73F0-4374-A5AF-B96C6BF3A8B1}" dt="2021-04-20T10:20:07.856" v="139"/>
          <ac:picMkLst>
            <pc:docMk/>
            <pc:sldMk cId="4227326657" sldId="278"/>
            <ac:picMk id="2" creationId="{B76F09DF-5120-422E-95C1-A2B0A33D63DE}"/>
          </ac:picMkLst>
        </pc:picChg>
        <pc:picChg chg="del">
          <ac:chgData name="maryam kandi" userId="3dae5b15da3a7b39" providerId="Windows Live" clId="Web-{4D7AB1A2-73F0-4374-A5AF-B96C6BF3A8B1}" dt="2021-04-20T10:20:59.995" v="146"/>
          <ac:picMkLst>
            <pc:docMk/>
            <pc:sldMk cId="4227326657" sldId="278"/>
            <ac:picMk id="3" creationId="{C077E209-C9A7-409B-905F-797E116E2EC6}"/>
          </ac:picMkLst>
        </pc:picChg>
        <pc:picChg chg="add mod">
          <ac:chgData name="maryam kandi" userId="3dae5b15da3a7b39" providerId="Windows Live" clId="Web-{4D7AB1A2-73F0-4374-A5AF-B96C6BF3A8B1}" dt="2021-04-20T10:20:28.449" v="144" actId="14100"/>
          <ac:picMkLst>
            <pc:docMk/>
            <pc:sldMk cId="4227326657" sldId="278"/>
            <ac:picMk id="5" creationId="{8A0E7612-D189-47B5-A5C1-7A017A3F5066}"/>
          </ac:picMkLst>
        </pc:picChg>
        <pc:picChg chg="add mod">
          <ac:chgData name="maryam kandi" userId="3dae5b15da3a7b39" providerId="Windows Live" clId="Web-{4D7AB1A2-73F0-4374-A5AF-B96C6BF3A8B1}" dt="2021-04-20T17:30:51.960" v="408" actId="1076"/>
          <ac:picMkLst>
            <pc:docMk/>
            <pc:sldMk cId="4227326657" sldId="278"/>
            <ac:picMk id="6" creationId="{3793D787-EA1E-45B4-9122-3779DD857C69}"/>
          </ac:picMkLst>
        </pc:picChg>
      </pc:sldChg>
      <pc:sldChg chg="addSp delSp modSp add mod replId modClrScheme chgLayout">
        <pc:chgData name="maryam kandi" userId="3dae5b15da3a7b39" providerId="Windows Live" clId="Web-{4D7AB1A2-73F0-4374-A5AF-B96C6BF3A8B1}" dt="2021-04-20T15:47:36.653" v="250" actId="14100"/>
        <pc:sldMkLst>
          <pc:docMk/>
          <pc:sldMk cId="1241460867" sldId="279"/>
        </pc:sldMkLst>
        <pc:spChg chg="mod ord">
          <ac:chgData name="maryam kandi" userId="3dae5b15da3a7b39" providerId="Windows Live" clId="Web-{4D7AB1A2-73F0-4374-A5AF-B96C6BF3A8B1}" dt="2021-04-20T15:47:00.434" v="243"/>
          <ac:spMkLst>
            <pc:docMk/>
            <pc:sldMk cId="1241460867" sldId="279"/>
            <ac:spMk id="4" creationId="{61734171-A701-DD48-A4FA-630F174A68B7}"/>
          </ac:spMkLst>
        </pc:spChg>
        <pc:picChg chg="del">
          <ac:chgData name="maryam kandi" userId="3dae5b15da3a7b39" providerId="Windows Live" clId="Web-{4D7AB1A2-73F0-4374-A5AF-B96C6BF3A8B1}" dt="2021-04-20T10:28:15.225" v="187"/>
          <ac:picMkLst>
            <pc:docMk/>
            <pc:sldMk cId="1241460867" sldId="279"/>
            <ac:picMk id="2" creationId="{F24F067C-E3F8-4045-B1DC-08D114E1B706}"/>
          </ac:picMkLst>
        </pc:picChg>
        <pc:picChg chg="add mod">
          <ac:chgData name="maryam kandi" userId="3dae5b15da3a7b39" providerId="Windows Live" clId="Web-{4D7AB1A2-73F0-4374-A5AF-B96C6BF3A8B1}" dt="2021-04-20T15:47:36.653" v="250" actId="14100"/>
          <ac:picMkLst>
            <pc:docMk/>
            <pc:sldMk cId="1241460867" sldId="279"/>
            <ac:picMk id="3" creationId="{AF58FDF7-0D57-4996-8C7D-E12DA6725D48}"/>
          </ac:picMkLst>
        </pc:picChg>
      </pc:sldChg>
      <pc:sldChg chg="addSp delSp modSp add mod replId modClrScheme chgLayout">
        <pc:chgData name="maryam kandi" userId="3dae5b15da3a7b39" providerId="Windows Live" clId="Web-{4D7AB1A2-73F0-4374-A5AF-B96C6BF3A8B1}" dt="2021-04-20T15:47:46.325" v="252" actId="14100"/>
        <pc:sldMkLst>
          <pc:docMk/>
          <pc:sldMk cId="3740693634" sldId="280"/>
        </pc:sldMkLst>
        <pc:spChg chg="mod">
          <ac:chgData name="maryam kandi" userId="3dae5b15da3a7b39" providerId="Windows Live" clId="Web-{4D7AB1A2-73F0-4374-A5AF-B96C6BF3A8B1}" dt="2021-04-20T10:30:06.506" v="202" actId="20577"/>
          <ac:spMkLst>
            <pc:docMk/>
            <pc:sldMk cId="3740693634" sldId="280"/>
            <ac:spMk id="4" creationId="{D8713651-F972-E44A-8921-6616912E36DD}"/>
          </ac:spMkLst>
        </pc:spChg>
        <pc:spChg chg="mod">
          <ac:chgData name="maryam kandi" userId="3dae5b15da3a7b39" providerId="Windows Live" clId="Web-{4D7AB1A2-73F0-4374-A5AF-B96C6BF3A8B1}" dt="2021-04-20T10:30:39.396" v="205" actId="20577"/>
          <ac:spMkLst>
            <pc:docMk/>
            <pc:sldMk cId="3740693634" sldId="280"/>
            <ac:spMk id="7" creationId="{2BA466B8-1321-AE4B-A475-D11804BC1F80}"/>
          </ac:spMkLst>
        </pc:spChg>
        <pc:picChg chg="add mod">
          <ac:chgData name="maryam kandi" userId="3dae5b15da3a7b39" providerId="Windows Live" clId="Web-{4D7AB1A2-73F0-4374-A5AF-B96C6BF3A8B1}" dt="2021-04-20T15:47:43.215" v="251" actId="14100"/>
          <ac:picMkLst>
            <pc:docMk/>
            <pc:sldMk cId="3740693634" sldId="280"/>
            <ac:picMk id="2" creationId="{2619BFCB-8548-408B-840D-2F5CEA847CF0}"/>
          </ac:picMkLst>
        </pc:picChg>
        <pc:picChg chg="add del mod">
          <ac:chgData name="maryam kandi" userId="3dae5b15da3a7b39" providerId="Windows Live" clId="Web-{4D7AB1A2-73F0-4374-A5AF-B96C6BF3A8B1}" dt="2021-04-20T15:47:07.996" v="245"/>
          <ac:picMkLst>
            <pc:docMk/>
            <pc:sldMk cId="3740693634" sldId="280"/>
            <ac:picMk id="3" creationId="{483022A4-2EA2-4E11-97D6-BF970859A8DC}"/>
          </ac:picMkLst>
        </pc:picChg>
        <pc:picChg chg="add del mod">
          <ac:chgData name="maryam kandi" userId="3dae5b15da3a7b39" providerId="Windows Live" clId="Web-{4D7AB1A2-73F0-4374-A5AF-B96C6BF3A8B1}" dt="2021-04-20T10:31:11.848" v="210"/>
          <ac:picMkLst>
            <pc:docMk/>
            <pc:sldMk cId="3740693634" sldId="280"/>
            <ac:picMk id="3" creationId="{F8C9679F-E25E-4EBB-B9D9-7DD6D6F9CE83}"/>
          </ac:picMkLst>
        </pc:picChg>
        <pc:picChg chg="del">
          <ac:chgData name="maryam kandi" userId="3dae5b15da3a7b39" providerId="Windows Live" clId="Web-{4D7AB1A2-73F0-4374-A5AF-B96C6BF3A8B1}" dt="2021-04-20T10:29:11.194" v="195"/>
          <ac:picMkLst>
            <pc:docMk/>
            <pc:sldMk cId="3740693634" sldId="280"/>
            <ac:picMk id="5" creationId="{8A0E7612-D189-47B5-A5C1-7A017A3F5066}"/>
          </ac:picMkLst>
        </pc:picChg>
        <pc:picChg chg="del mod">
          <ac:chgData name="maryam kandi" userId="3dae5b15da3a7b39" providerId="Windows Live" clId="Web-{4D7AB1A2-73F0-4374-A5AF-B96C6BF3A8B1}" dt="2021-04-20T10:30:57.692" v="206"/>
          <ac:picMkLst>
            <pc:docMk/>
            <pc:sldMk cId="3740693634" sldId="280"/>
            <ac:picMk id="6" creationId="{3793D787-EA1E-45B4-9122-3779DD857C69}"/>
          </ac:picMkLst>
        </pc:picChg>
        <pc:picChg chg="add del mod">
          <ac:chgData name="maryam kandi" userId="3dae5b15da3a7b39" providerId="Windows Live" clId="Web-{4D7AB1A2-73F0-4374-A5AF-B96C6BF3A8B1}" dt="2021-04-20T10:31:08.848" v="209"/>
          <ac:picMkLst>
            <pc:docMk/>
            <pc:sldMk cId="3740693634" sldId="280"/>
            <ac:picMk id="8" creationId="{E5B2ED3A-DA84-42AF-8159-B6CAF641617E}"/>
          </ac:picMkLst>
        </pc:picChg>
        <pc:picChg chg="add mod">
          <ac:chgData name="maryam kandi" userId="3dae5b15da3a7b39" providerId="Windows Live" clId="Web-{4D7AB1A2-73F0-4374-A5AF-B96C6BF3A8B1}" dt="2021-04-20T15:47:46.325" v="252" actId="14100"/>
          <ac:picMkLst>
            <pc:docMk/>
            <pc:sldMk cId="3740693634" sldId="280"/>
            <ac:picMk id="9" creationId="{638C89CC-6AA0-49C3-A66F-E38E6D98B9AA}"/>
          </ac:picMkLst>
        </pc:picChg>
      </pc:sldChg>
      <pc:sldChg chg="addSp delSp modSp add mod replId setBg modClrScheme delDesignElem chgLayout">
        <pc:chgData name="maryam kandi" userId="3dae5b15da3a7b39" providerId="Windows Live" clId="Web-{4D7AB1A2-73F0-4374-A5AF-B96C6BF3A8B1}" dt="2021-04-20T15:47:21.715" v="248" actId="14100"/>
        <pc:sldMkLst>
          <pc:docMk/>
          <pc:sldMk cId="3677971173" sldId="281"/>
        </pc:sldMkLst>
        <pc:spChg chg="mod ord">
          <ac:chgData name="maryam kandi" userId="3dae5b15da3a7b39" providerId="Windows Live" clId="Web-{4D7AB1A2-73F0-4374-A5AF-B96C6BF3A8B1}" dt="2021-04-20T15:47:10.575" v="246"/>
          <ac:spMkLst>
            <pc:docMk/>
            <pc:sldMk cId="3677971173" sldId="281"/>
            <ac:spMk id="4" creationId="{61734171-A701-DD48-A4FA-630F174A68B7}"/>
          </ac:spMkLst>
        </pc:spChg>
        <pc:spChg chg="add del">
          <ac:chgData name="maryam kandi" userId="3dae5b15da3a7b39" providerId="Windows Live" clId="Web-{4D7AB1A2-73F0-4374-A5AF-B96C6BF3A8B1}" dt="2021-04-20T15:47:10.575" v="246"/>
          <ac:spMkLst>
            <pc:docMk/>
            <pc:sldMk cId="3677971173" sldId="281"/>
            <ac:spMk id="6" creationId="{A4AC5506-6312-4701-8D3C-40187889A947}"/>
          </ac:spMkLst>
        </pc:spChg>
        <pc:spChg chg="add del">
          <ac:chgData name="maryam kandi" userId="3dae5b15da3a7b39" providerId="Windows Live" clId="Web-{4D7AB1A2-73F0-4374-A5AF-B96C6BF3A8B1}" dt="2021-04-20T15:45:29.746" v="232"/>
          <ac:spMkLst>
            <pc:docMk/>
            <pc:sldMk cId="3677971173" sldId="281"/>
            <ac:spMk id="9" creationId="{D4771268-CB57-404A-9271-370EB28F6090}"/>
          </ac:spMkLst>
        </pc:spChg>
        <pc:picChg chg="add mod">
          <ac:chgData name="maryam kandi" userId="3dae5b15da3a7b39" providerId="Windows Live" clId="Web-{4D7AB1A2-73F0-4374-A5AF-B96C6BF3A8B1}" dt="2021-04-20T15:47:21.715" v="248" actId="14100"/>
          <ac:picMkLst>
            <pc:docMk/>
            <pc:sldMk cId="3677971173" sldId="281"/>
            <ac:picMk id="2" creationId="{BA598561-D1F9-4DDD-9743-AE6CF3B53CF2}"/>
          </ac:picMkLst>
        </pc:picChg>
        <pc:picChg chg="del">
          <ac:chgData name="maryam kandi" userId="3dae5b15da3a7b39" providerId="Windows Live" clId="Web-{4D7AB1A2-73F0-4374-A5AF-B96C6BF3A8B1}" dt="2021-04-20T15:45:12.949" v="229"/>
          <ac:picMkLst>
            <pc:docMk/>
            <pc:sldMk cId="3677971173" sldId="281"/>
            <ac:picMk id="3" creationId="{AF58FDF7-0D57-4996-8C7D-E12DA6725D48}"/>
          </ac:picMkLst>
        </pc:picChg>
      </pc:sldChg>
      <pc:sldChg chg="addSp delSp modSp add replId">
        <pc:chgData name="maryam kandi" userId="3dae5b15da3a7b39" providerId="Windows Live" clId="Web-{4D7AB1A2-73F0-4374-A5AF-B96C6BF3A8B1}" dt="2021-04-20T15:54:28.794" v="263" actId="14100"/>
        <pc:sldMkLst>
          <pc:docMk/>
          <pc:sldMk cId="3062482854" sldId="282"/>
        </pc:sldMkLst>
        <pc:spChg chg="mod">
          <ac:chgData name="maryam kandi" userId="3dae5b15da3a7b39" providerId="Windows Live" clId="Web-{4D7AB1A2-73F0-4374-A5AF-B96C6BF3A8B1}" dt="2021-04-20T15:54:10.638" v="258" actId="20577"/>
          <ac:spMkLst>
            <pc:docMk/>
            <pc:sldMk cId="3062482854" sldId="282"/>
            <ac:spMk id="4" creationId="{61734171-A701-DD48-A4FA-630F174A68B7}"/>
          </ac:spMkLst>
        </pc:spChg>
        <pc:picChg chg="del">
          <ac:chgData name="maryam kandi" userId="3dae5b15da3a7b39" providerId="Windows Live" clId="Web-{4D7AB1A2-73F0-4374-A5AF-B96C6BF3A8B1}" dt="2021-04-20T15:54:11.373" v="259"/>
          <ac:picMkLst>
            <pc:docMk/>
            <pc:sldMk cId="3062482854" sldId="282"/>
            <ac:picMk id="2" creationId="{F24F067C-E3F8-4045-B1DC-08D114E1B706}"/>
          </ac:picMkLst>
        </pc:picChg>
        <pc:picChg chg="add mod">
          <ac:chgData name="maryam kandi" userId="3dae5b15da3a7b39" providerId="Windows Live" clId="Web-{4D7AB1A2-73F0-4374-A5AF-B96C6BF3A8B1}" dt="2021-04-20T15:54:28.794" v="263" actId="14100"/>
          <ac:picMkLst>
            <pc:docMk/>
            <pc:sldMk cId="3062482854" sldId="282"/>
            <ac:picMk id="3" creationId="{355BDF76-1299-4C36-9FBB-5B49E790778F}"/>
          </ac:picMkLst>
        </pc:picChg>
      </pc:sldChg>
      <pc:sldChg chg="addSp delSp modSp add replId">
        <pc:chgData name="maryam kandi" userId="3dae5b15da3a7b39" providerId="Windows Live" clId="Web-{4D7AB1A2-73F0-4374-A5AF-B96C6BF3A8B1}" dt="2021-04-20T15:57:48.826" v="282" actId="1076"/>
        <pc:sldMkLst>
          <pc:docMk/>
          <pc:sldMk cId="2580570343" sldId="283"/>
        </pc:sldMkLst>
        <pc:spChg chg="mod">
          <ac:chgData name="maryam kandi" userId="3dae5b15da3a7b39" providerId="Windows Live" clId="Web-{4D7AB1A2-73F0-4374-A5AF-B96C6BF3A8B1}" dt="2021-04-20T15:57:48.826" v="282" actId="1076"/>
          <ac:spMkLst>
            <pc:docMk/>
            <pc:sldMk cId="2580570343" sldId="283"/>
            <ac:spMk id="4" creationId="{61734171-A701-DD48-A4FA-630F174A68B7}"/>
          </ac:spMkLst>
        </pc:spChg>
        <pc:picChg chg="add mod">
          <ac:chgData name="maryam kandi" userId="3dae5b15da3a7b39" providerId="Windows Live" clId="Web-{4D7AB1A2-73F0-4374-A5AF-B96C6BF3A8B1}" dt="2021-04-20T15:57:41.826" v="281" actId="14100"/>
          <ac:picMkLst>
            <pc:docMk/>
            <pc:sldMk cId="2580570343" sldId="283"/>
            <ac:picMk id="2" creationId="{5DCABC5E-85EA-4643-8D66-C277D25FFE99}"/>
          </ac:picMkLst>
        </pc:picChg>
        <pc:picChg chg="del">
          <ac:chgData name="maryam kandi" userId="3dae5b15da3a7b39" providerId="Windows Live" clId="Web-{4D7AB1A2-73F0-4374-A5AF-B96C6BF3A8B1}" dt="2021-04-20T15:57:25.639" v="278"/>
          <ac:picMkLst>
            <pc:docMk/>
            <pc:sldMk cId="2580570343" sldId="283"/>
            <ac:picMk id="3" creationId="{355BDF76-1299-4C36-9FBB-5B49E790778F}"/>
          </ac:picMkLst>
        </pc:picChg>
      </pc:sldChg>
      <pc:sldChg chg="addSp delSp modSp add replId">
        <pc:chgData name="maryam kandi" userId="3dae5b15da3a7b39" providerId="Windows Live" clId="Web-{4D7AB1A2-73F0-4374-A5AF-B96C6BF3A8B1}" dt="2021-04-20T16:10:12.719" v="308" actId="14100"/>
        <pc:sldMkLst>
          <pc:docMk/>
          <pc:sldMk cId="3429394467" sldId="284"/>
        </pc:sldMkLst>
        <pc:spChg chg="mod">
          <ac:chgData name="maryam kandi" userId="3dae5b15da3a7b39" providerId="Windows Live" clId="Web-{4D7AB1A2-73F0-4374-A5AF-B96C6BF3A8B1}" dt="2021-04-20T15:59:49.092" v="287" actId="20577"/>
          <ac:spMkLst>
            <pc:docMk/>
            <pc:sldMk cId="3429394467" sldId="284"/>
            <ac:spMk id="4" creationId="{61734171-A701-DD48-A4FA-630F174A68B7}"/>
          </ac:spMkLst>
        </pc:spChg>
        <pc:picChg chg="add del mod">
          <ac:chgData name="maryam kandi" userId="3dae5b15da3a7b39" providerId="Windows Live" clId="Web-{4D7AB1A2-73F0-4374-A5AF-B96C6BF3A8B1}" dt="2021-04-20T16:09:53.656" v="303"/>
          <ac:picMkLst>
            <pc:docMk/>
            <pc:sldMk cId="3429394467" sldId="284"/>
            <ac:picMk id="2" creationId="{568E1100-D8DE-4B1F-9B59-841C8AC6EFD4}"/>
          </ac:picMkLst>
        </pc:picChg>
        <pc:picChg chg="del">
          <ac:chgData name="maryam kandi" userId="3dae5b15da3a7b39" providerId="Windows Live" clId="Web-{4D7AB1A2-73F0-4374-A5AF-B96C6BF3A8B1}" dt="2021-04-20T16:00:25.592" v="288"/>
          <ac:picMkLst>
            <pc:docMk/>
            <pc:sldMk cId="3429394467" sldId="284"/>
            <ac:picMk id="3" creationId="{355BDF76-1299-4C36-9FBB-5B49E790778F}"/>
          </ac:picMkLst>
        </pc:picChg>
        <pc:picChg chg="add mod">
          <ac:chgData name="maryam kandi" userId="3dae5b15da3a7b39" providerId="Windows Live" clId="Web-{4D7AB1A2-73F0-4374-A5AF-B96C6BF3A8B1}" dt="2021-04-20T16:10:12.719" v="308" actId="14100"/>
          <ac:picMkLst>
            <pc:docMk/>
            <pc:sldMk cId="3429394467" sldId="284"/>
            <ac:picMk id="5" creationId="{32F3424B-C44A-4853-908E-803F3B1B2F94}"/>
          </ac:picMkLst>
        </pc:picChg>
      </pc:sldChg>
      <pc:sldChg chg="addSp delSp modSp add replId">
        <pc:chgData name="maryam kandi" userId="3dae5b15da3a7b39" providerId="Windows Live" clId="Web-{4D7AB1A2-73F0-4374-A5AF-B96C6BF3A8B1}" dt="2021-04-20T16:08:15.687" v="302" actId="14100"/>
        <pc:sldMkLst>
          <pc:docMk/>
          <pc:sldMk cId="1455419981" sldId="285"/>
        </pc:sldMkLst>
        <pc:spChg chg="mod">
          <ac:chgData name="maryam kandi" userId="3dae5b15da3a7b39" providerId="Windows Live" clId="Web-{4D7AB1A2-73F0-4374-A5AF-B96C6BF3A8B1}" dt="2021-04-20T16:01:41.374" v="298" actId="20577"/>
          <ac:spMkLst>
            <pc:docMk/>
            <pc:sldMk cId="1455419981" sldId="285"/>
            <ac:spMk id="4" creationId="{61734171-A701-DD48-A4FA-630F174A68B7}"/>
          </ac:spMkLst>
        </pc:spChg>
        <pc:picChg chg="add mod">
          <ac:chgData name="maryam kandi" userId="3dae5b15da3a7b39" providerId="Windows Live" clId="Web-{4D7AB1A2-73F0-4374-A5AF-B96C6BF3A8B1}" dt="2021-04-20T16:08:15.687" v="302" actId="14100"/>
          <ac:picMkLst>
            <pc:docMk/>
            <pc:sldMk cId="1455419981" sldId="285"/>
            <ac:picMk id="2" creationId="{83AC47EE-5E38-49B5-8122-EF0946066917}"/>
          </ac:picMkLst>
        </pc:picChg>
        <pc:picChg chg="del">
          <ac:chgData name="maryam kandi" userId="3dae5b15da3a7b39" providerId="Windows Live" clId="Web-{4D7AB1A2-73F0-4374-A5AF-B96C6BF3A8B1}" dt="2021-04-20T16:08:02.453" v="299"/>
          <ac:picMkLst>
            <pc:docMk/>
            <pc:sldMk cId="1455419981" sldId="285"/>
            <ac:picMk id="3" creationId="{355BDF76-1299-4C36-9FBB-5B49E790778F}"/>
          </ac:picMkLst>
        </pc:picChg>
      </pc:sldChg>
      <pc:sldChg chg="addSp delSp modSp add replId">
        <pc:chgData name="maryam kandi" userId="3dae5b15da3a7b39" providerId="Windows Live" clId="Web-{4D7AB1A2-73F0-4374-A5AF-B96C6BF3A8B1}" dt="2021-04-20T17:35:18.083" v="412" actId="20577"/>
        <pc:sldMkLst>
          <pc:docMk/>
          <pc:sldMk cId="4077971974" sldId="286"/>
        </pc:sldMkLst>
        <pc:spChg chg="mod">
          <ac:chgData name="maryam kandi" userId="3dae5b15da3a7b39" providerId="Windows Live" clId="Web-{4D7AB1A2-73F0-4374-A5AF-B96C6BF3A8B1}" dt="2021-04-20T17:35:18.083" v="412" actId="20577"/>
          <ac:spMkLst>
            <pc:docMk/>
            <pc:sldMk cId="4077971974" sldId="286"/>
            <ac:spMk id="4" creationId="{61734171-A701-DD48-A4FA-630F174A68B7}"/>
          </ac:spMkLst>
        </pc:spChg>
        <pc:picChg chg="add mod">
          <ac:chgData name="maryam kandi" userId="3dae5b15da3a7b39" providerId="Windows Live" clId="Web-{4D7AB1A2-73F0-4374-A5AF-B96C6BF3A8B1}" dt="2021-04-20T16:12:29.876" v="320" actId="14100"/>
          <ac:picMkLst>
            <pc:docMk/>
            <pc:sldMk cId="4077971974" sldId="286"/>
            <ac:picMk id="2" creationId="{49993693-34AF-48A3-B881-88D61FDA7FC3}"/>
          </ac:picMkLst>
        </pc:picChg>
        <pc:picChg chg="del">
          <ac:chgData name="maryam kandi" userId="3dae5b15da3a7b39" providerId="Windows Live" clId="Web-{4D7AB1A2-73F0-4374-A5AF-B96C6BF3A8B1}" dt="2021-04-20T16:12:10.438" v="316"/>
          <ac:picMkLst>
            <pc:docMk/>
            <pc:sldMk cId="4077971974" sldId="286"/>
            <ac:picMk id="5" creationId="{32F3424B-C44A-4853-908E-803F3B1B2F94}"/>
          </ac:picMkLst>
        </pc:picChg>
      </pc:sldChg>
      <pc:sldChg chg="addSp delSp modSp add replId">
        <pc:chgData name="maryam kandi" userId="3dae5b15da3a7b39" providerId="Windows Live" clId="Web-{4D7AB1A2-73F0-4374-A5AF-B96C6BF3A8B1}" dt="2021-04-20T16:14:04.016" v="332" actId="14100"/>
        <pc:sldMkLst>
          <pc:docMk/>
          <pc:sldMk cId="3458785798" sldId="287"/>
        </pc:sldMkLst>
        <pc:spChg chg="mod">
          <ac:chgData name="maryam kandi" userId="3dae5b15da3a7b39" providerId="Windows Live" clId="Web-{4D7AB1A2-73F0-4374-A5AF-B96C6BF3A8B1}" dt="2021-04-20T16:13:21.970" v="326" actId="20577"/>
          <ac:spMkLst>
            <pc:docMk/>
            <pc:sldMk cId="3458785798" sldId="287"/>
            <ac:spMk id="4" creationId="{61734171-A701-DD48-A4FA-630F174A68B7}"/>
          </ac:spMkLst>
        </pc:spChg>
        <pc:picChg chg="add mod">
          <ac:chgData name="maryam kandi" userId="3dae5b15da3a7b39" providerId="Windows Live" clId="Web-{4D7AB1A2-73F0-4374-A5AF-B96C6BF3A8B1}" dt="2021-04-20T16:14:04.016" v="332" actId="14100"/>
          <ac:picMkLst>
            <pc:docMk/>
            <pc:sldMk cId="3458785798" sldId="287"/>
            <ac:picMk id="2" creationId="{2B3B2A9D-EF94-4B65-BEDB-106D30D5AC55}"/>
          </ac:picMkLst>
        </pc:picChg>
        <pc:picChg chg="del">
          <ac:chgData name="maryam kandi" userId="3dae5b15da3a7b39" providerId="Windows Live" clId="Web-{4D7AB1A2-73F0-4374-A5AF-B96C6BF3A8B1}" dt="2021-04-20T16:13:46.751" v="327"/>
          <ac:picMkLst>
            <pc:docMk/>
            <pc:sldMk cId="3458785798" sldId="287"/>
            <ac:picMk id="5" creationId="{32F3424B-C44A-4853-908E-803F3B1B2F94}"/>
          </ac:picMkLst>
        </pc:picChg>
      </pc:sldChg>
      <pc:sldMasterChg chg="add del addSldLayout delSldLayout">
        <pc:chgData name="maryam kandi" userId="3dae5b15da3a7b39" providerId="Windows Live" clId="Web-{4D7AB1A2-73F0-4374-A5AF-B96C6BF3A8B1}" dt="2021-04-20T15:47:00.434" v="243"/>
        <pc:sldMasterMkLst>
          <pc:docMk/>
          <pc:sldMasterMk cId="4260453759" sldId="2147483648"/>
        </pc:sldMasterMkLst>
        <pc:sldLayoutChg chg="add del">
          <pc:chgData name="maryam kandi" userId="3dae5b15da3a7b39" providerId="Windows Live" clId="Web-{4D7AB1A2-73F0-4374-A5AF-B96C6BF3A8B1}" dt="2021-04-20T15:47:00.434" v="243"/>
          <pc:sldLayoutMkLst>
            <pc:docMk/>
            <pc:sldMasterMk cId="4260453759" sldId="2147483648"/>
            <pc:sldLayoutMk cId="9968266" sldId="2147483649"/>
          </pc:sldLayoutMkLst>
        </pc:sldLayoutChg>
        <pc:sldLayoutChg chg="add del">
          <pc:chgData name="maryam kandi" userId="3dae5b15da3a7b39" providerId="Windows Live" clId="Web-{4D7AB1A2-73F0-4374-A5AF-B96C6BF3A8B1}" dt="2021-04-20T15:47:00.434" v="243"/>
          <pc:sldLayoutMkLst>
            <pc:docMk/>
            <pc:sldMasterMk cId="4260453759" sldId="2147483648"/>
            <pc:sldLayoutMk cId="3764296820" sldId="2147483650"/>
          </pc:sldLayoutMkLst>
        </pc:sldLayoutChg>
        <pc:sldLayoutChg chg="add del">
          <pc:chgData name="maryam kandi" userId="3dae5b15da3a7b39" providerId="Windows Live" clId="Web-{4D7AB1A2-73F0-4374-A5AF-B96C6BF3A8B1}" dt="2021-04-20T15:47:00.434" v="243"/>
          <pc:sldLayoutMkLst>
            <pc:docMk/>
            <pc:sldMasterMk cId="4260453759" sldId="2147483648"/>
            <pc:sldLayoutMk cId="561357054" sldId="2147483651"/>
          </pc:sldLayoutMkLst>
        </pc:sldLayoutChg>
        <pc:sldLayoutChg chg="add del">
          <pc:chgData name="maryam kandi" userId="3dae5b15da3a7b39" providerId="Windows Live" clId="Web-{4D7AB1A2-73F0-4374-A5AF-B96C6BF3A8B1}" dt="2021-04-20T15:47:00.434" v="243"/>
          <pc:sldLayoutMkLst>
            <pc:docMk/>
            <pc:sldMasterMk cId="4260453759" sldId="2147483648"/>
            <pc:sldLayoutMk cId="3361339002" sldId="2147483652"/>
          </pc:sldLayoutMkLst>
        </pc:sldLayoutChg>
        <pc:sldLayoutChg chg="add del">
          <pc:chgData name="maryam kandi" userId="3dae5b15da3a7b39" providerId="Windows Live" clId="Web-{4D7AB1A2-73F0-4374-A5AF-B96C6BF3A8B1}" dt="2021-04-20T15:47:00.434" v="243"/>
          <pc:sldLayoutMkLst>
            <pc:docMk/>
            <pc:sldMasterMk cId="4260453759" sldId="2147483648"/>
            <pc:sldLayoutMk cId="1053296752" sldId="2147483653"/>
          </pc:sldLayoutMkLst>
        </pc:sldLayoutChg>
        <pc:sldLayoutChg chg="add del">
          <pc:chgData name="maryam kandi" userId="3dae5b15da3a7b39" providerId="Windows Live" clId="Web-{4D7AB1A2-73F0-4374-A5AF-B96C6BF3A8B1}" dt="2021-04-20T15:47:00.434" v="243"/>
          <pc:sldLayoutMkLst>
            <pc:docMk/>
            <pc:sldMasterMk cId="4260453759" sldId="2147483648"/>
            <pc:sldLayoutMk cId="3500103731" sldId="2147483654"/>
          </pc:sldLayoutMkLst>
        </pc:sldLayoutChg>
        <pc:sldLayoutChg chg="add del">
          <pc:chgData name="maryam kandi" userId="3dae5b15da3a7b39" providerId="Windows Live" clId="Web-{4D7AB1A2-73F0-4374-A5AF-B96C6BF3A8B1}" dt="2021-04-20T15:47:00.434" v="243"/>
          <pc:sldLayoutMkLst>
            <pc:docMk/>
            <pc:sldMasterMk cId="4260453759" sldId="2147483648"/>
            <pc:sldLayoutMk cId="4218694514" sldId="2147483655"/>
          </pc:sldLayoutMkLst>
        </pc:sldLayoutChg>
        <pc:sldLayoutChg chg="add del">
          <pc:chgData name="maryam kandi" userId="3dae5b15da3a7b39" providerId="Windows Live" clId="Web-{4D7AB1A2-73F0-4374-A5AF-B96C6BF3A8B1}" dt="2021-04-20T15:47:00.434" v="243"/>
          <pc:sldLayoutMkLst>
            <pc:docMk/>
            <pc:sldMasterMk cId="4260453759" sldId="2147483648"/>
            <pc:sldLayoutMk cId="2965097241" sldId="2147483656"/>
          </pc:sldLayoutMkLst>
        </pc:sldLayoutChg>
        <pc:sldLayoutChg chg="add del">
          <pc:chgData name="maryam kandi" userId="3dae5b15da3a7b39" providerId="Windows Live" clId="Web-{4D7AB1A2-73F0-4374-A5AF-B96C6BF3A8B1}" dt="2021-04-20T15:47:00.434" v="243"/>
          <pc:sldLayoutMkLst>
            <pc:docMk/>
            <pc:sldMasterMk cId="4260453759" sldId="2147483648"/>
            <pc:sldLayoutMk cId="787066401" sldId="2147483657"/>
          </pc:sldLayoutMkLst>
        </pc:sldLayoutChg>
        <pc:sldLayoutChg chg="add del">
          <pc:chgData name="maryam kandi" userId="3dae5b15da3a7b39" providerId="Windows Live" clId="Web-{4D7AB1A2-73F0-4374-A5AF-B96C6BF3A8B1}" dt="2021-04-20T15:47:00.434" v="243"/>
          <pc:sldLayoutMkLst>
            <pc:docMk/>
            <pc:sldMasterMk cId="4260453759" sldId="2147483648"/>
            <pc:sldLayoutMk cId="4178444797" sldId="2147483658"/>
          </pc:sldLayoutMkLst>
        </pc:sldLayoutChg>
        <pc:sldLayoutChg chg="add del">
          <pc:chgData name="maryam kandi" userId="3dae5b15da3a7b39" providerId="Windows Live" clId="Web-{4D7AB1A2-73F0-4374-A5AF-B96C6BF3A8B1}" dt="2021-04-20T15:47:00.434" v="243"/>
          <pc:sldLayoutMkLst>
            <pc:docMk/>
            <pc:sldMasterMk cId="4260453759" sldId="2147483648"/>
            <pc:sldLayoutMk cId="483992326" sldId="2147483659"/>
          </pc:sldLayoutMkLst>
        </pc:sldLayoutChg>
      </pc:sldMasterChg>
      <pc:sldMasterChg chg="add del addSldLayout delSldLayout modSldLayout">
        <pc:chgData name="maryam kandi" userId="3dae5b15da3a7b39" providerId="Windows Live" clId="Web-{4D7AB1A2-73F0-4374-A5AF-B96C6BF3A8B1}" dt="2021-04-20T15:47:00.434" v="243"/>
        <pc:sldMasterMkLst>
          <pc:docMk/>
          <pc:sldMasterMk cId="2485649874" sldId="2147483660"/>
        </pc:sldMasterMkLst>
        <pc:sldLayoutChg chg="add del mod replId">
          <pc:chgData name="maryam kandi" userId="3dae5b15da3a7b39" providerId="Windows Live" clId="Web-{4D7AB1A2-73F0-4374-A5AF-B96C6BF3A8B1}" dt="2021-04-20T15:47:00.434" v="243"/>
          <pc:sldLayoutMkLst>
            <pc:docMk/>
            <pc:sldMasterMk cId="2485649874" sldId="2147483660"/>
            <pc:sldLayoutMk cId="3854988255" sldId="2147483661"/>
          </pc:sldLayoutMkLst>
        </pc:sldLayoutChg>
        <pc:sldLayoutChg chg="add del mod replId">
          <pc:chgData name="maryam kandi" userId="3dae5b15da3a7b39" providerId="Windows Live" clId="Web-{4D7AB1A2-73F0-4374-A5AF-B96C6BF3A8B1}" dt="2021-04-20T15:47:00.434" v="243"/>
          <pc:sldLayoutMkLst>
            <pc:docMk/>
            <pc:sldMasterMk cId="2485649874" sldId="2147483660"/>
            <pc:sldLayoutMk cId="2147851253" sldId="2147483662"/>
          </pc:sldLayoutMkLst>
        </pc:sldLayoutChg>
        <pc:sldLayoutChg chg="add del mod replId">
          <pc:chgData name="maryam kandi" userId="3dae5b15da3a7b39" providerId="Windows Live" clId="Web-{4D7AB1A2-73F0-4374-A5AF-B96C6BF3A8B1}" dt="2021-04-20T15:47:00.434" v="243"/>
          <pc:sldLayoutMkLst>
            <pc:docMk/>
            <pc:sldMasterMk cId="2485649874" sldId="2147483660"/>
            <pc:sldLayoutMk cId="2614785176" sldId="2147483663"/>
          </pc:sldLayoutMkLst>
        </pc:sldLayoutChg>
        <pc:sldLayoutChg chg="add del mod replId">
          <pc:chgData name="maryam kandi" userId="3dae5b15da3a7b39" providerId="Windows Live" clId="Web-{4D7AB1A2-73F0-4374-A5AF-B96C6BF3A8B1}" dt="2021-04-20T15:47:00.434" v="243"/>
          <pc:sldLayoutMkLst>
            <pc:docMk/>
            <pc:sldMasterMk cId="2485649874" sldId="2147483660"/>
            <pc:sldLayoutMk cId="2416366474" sldId="2147483664"/>
          </pc:sldLayoutMkLst>
        </pc:sldLayoutChg>
        <pc:sldLayoutChg chg="add del mod replId">
          <pc:chgData name="maryam kandi" userId="3dae5b15da3a7b39" providerId="Windows Live" clId="Web-{4D7AB1A2-73F0-4374-A5AF-B96C6BF3A8B1}" dt="2021-04-20T15:47:00.434" v="243"/>
          <pc:sldLayoutMkLst>
            <pc:docMk/>
            <pc:sldMasterMk cId="2485649874" sldId="2147483660"/>
            <pc:sldLayoutMk cId="3421057814" sldId="2147483665"/>
          </pc:sldLayoutMkLst>
        </pc:sldLayoutChg>
        <pc:sldLayoutChg chg="add del mod replId">
          <pc:chgData name="maryam kandi" userId="3dae5b15da3a7b39" providerId="Windows Live" clId="Web-{4D7AB1A2-73F0-4374-A5AF-B96C6BF3A8B1}" dt="2021-04-20T15:47:00.434" v="243"/>
          <pc:sldLayoutMkLst>
            <pc:docMk/>
            <pc:sldMasterMk cId="2485649874" sldId="2147483660"/>
            <pc:sldLayoutMk cId="3694075667" sldId="2147483666"/>
          </pc:sldLayoutMkLst>
        </pc:sldLayoutChg>
        <pc:sldLayoutChg chg="add del mod replId">
          <pc:chgData name="maryam kandi" userId="3dae5b15da3a7b39" providerId="Windows Live" clId="Web-{4D7AB1A2-73F0-4374-A5AF-B96C6BF3A8B1}" dt="2021-04-20T15:47:00.434" v="243"/>
          <pc:sldLayoutMkLst>
            <pc:docMk/>
            <pc:sldMasterMk cId="2485649874" sldId="2147483660"/>
            <pc:sldLayoutMk cId="869777937" sldId="2147483667"/>
          </pc:sldLayoutMkLst>
        </pc:sldLayoutChg>
        <pc:sldLayoutChg chg="add del mod replId">
          <pc:chgData name="maryam kandi" userId="3dae5b15da3a7b39" providerId="Windows Live" clId="Web-{4D7AB1A2-73F0-4374-A5AF-B96C6BF3A8B1}" dt="2021-04-20T15:47:00.434" v="243"/>
          <pc:sldLayoutMkLst>
            <pc:docMk/>
            <pc:sldMasterMk cId="2485649874" sldId="2147483660"/>
            <pc:sldLayoutMk cId="1899540381" sldId="2147483668"/>
          </pc:sldLayoutMkLst>
        </pc:sldLayoutChg>
        <pc:sldLayoutChg chg="add del mod replId">
          <pc:chgData name="maryam kandi" userId="3dae5b15da3a7b39" providerId="Windows Live" clId="Web-{4D7AB1A2-73F0-4374-A5AF-B96C6BF3A8B1}" dt="2021-04-20T15:47:00.434" v="243"/>
          <pc:sldLayoutMkLst>
            <pc:docMk/>
            <pc:sldMasterMk cId="2485649874" sldId="2147483660"/>
            <pc:sldLayoutMk cId="3592657838" sldId="2147483669"/>
          </pc:sldLayoutMkLst>
        </pc:sldLayoutChg>
        <pc:sldLayoutChg chg="add del mod replId">
          <pc:chgData name="maryam kandi" userId="3dae5b15da3a7b39" providerId="Windows Live" clId="Web-{4D7AB1A2-73F0-4374-A5AF-B96C6BF3A8B1}" dt="2021-04-20T15:47:00.434" v="243"/>
          <pc:sldLayoutMkLst>
            <pc:docMk/>
            <pc:sldMasterMk cId="2485649874" sldId="2147483660"/>
            <pc:sldLayoutMk cId="1225399759" sldId="2147483670"/>
          </pc:sldLayoutMkLst>
        </pc:sldLayoutChg>
        <pc:sldLayoutChg chg="add del mod replId">
          <pc:chgData name="maryam kandi" userId="3dae5b15da3a7b39" providerId="Windows Live" clId="Web-{4D7AB1A2-73F0-4374-A5AF-B96C6BF3A8B1}" dt="2021-04-20T15:47:00.434" v="243"/>
          <pc:sldLayoutMkLst>
            <pc:docMk/>
            <pc:sldMasterMk cId="2485649874" sldId="2147483660"/>
            <pc:sldLayoutMk cId="3288599054" sldId="2147483671"/>
          </pc:sldLayoutMkLst>
        </pc:sldLayoutChg>
      </pc:sldMasterChg>
      <pc:sldMasterChg chg="add del addSldLayout delSldLayout modSldLayout">
        <pc:chgData name="maryam kandi" userId="3dae5b15da3a7b39" providerId="Windows Live" clId="Web-{4D7AB1A2-73F0-4374-A5AF-B96C6BF3A8B1}" dt="2021-04-20T15:46:52.543" v="240"/>
        <pc:sldMasterMkLst>
          <pc:docMk/>
          <pc:sldMasterMk cId="1517295786" sldId="2147483672"/>
        </pc:sldMasterMkLst>
        <pc:sldLayoutChg chg="add del mod replId">
          <pc:chgData name="maryam kandi" userId="3dae5b15da3a7b39" providerId="Windows Live" clId="Web-{4D7AB1A2-73F0-4374-A5AF-B96C6BF3A8B1}" dt="2021-04-20T15:46:52.543" v="240"/>
          <pc:sldLayoutMkLst>
            <pc:docMk/>
            <pc:sldMasterMk cId="1517295786" sldId="2147483672"/>
            <pc:sldLayoutMk cId="1873403644" sldId="2147483673"/>
          </pc:sldLayoutMkLst>
        </pc:sldLayoutChg>
        <pc:sldLayoutChg chg="add del mod replId">
          <pc:chgData name="maryam kandi" userId="3dae5b15da3a7b39" providerId="Windows Live" clId="Web-{4D7AB1A2-73F0-4374-A5AF-B96C6BF3A8B1}" dt="2021-04-20T15:46:52.543" v="240"/>
          <pc:sldLayoutMkLst>
            <pc:docMk/>
            <pc:sldMasterMk cId="1517295786" sldId="2147483672"/>
            <pc:sldLayoutMk cId="2554285809" sldId="2147483674"/>
          </pc:sldLayoutMkLst>
        </pc:sldLayoutChg>
        <pc:sldLayoutChg chg="add del mod replId">
          <pc:chgData name="maryam kandi" userId="3dae5b15da3a7b39" providerId="Windows Live" clId="Web-{4D7AB1A2-73F0-4374-A5AF-B96C6BF3A8B1}" dt="2021-04-20T15:46:52.543" v="240"/>
          <pc:sldLayoutMkLst>
            <pc:docMk/>
            <pc:sldMasterMk cId="1517295786" sldId="2147483672"/>
            <pc:sldLayoutMk cId="110801170" sldId="2147483675"/>
          </pc:sldLayoutMkLst>
        </pc:sldLayoutChg>
        <pc:sldLayoutChg chg="add del mod replId">
          <pc:chgData name="maryam kandi" userId="3dae5b15da3a7b39" providerId="Windows Live" clId="Web-{4D7AB1A2-73F0-4374-A5AF-B96C6BF3A8B1}" dt="2021-04-20T15:46:52.543" v="240"/>
          <pc:sldLayoutMkLst>
            <pc:docMk/>
            <pc:sldMasterMk cId="1517295786" sldId="2147483672"/>
            <pc:sldLayoutMk cId="3598359849" sldId="2147483676"/>
          </pc:sldLayoutMkLst>
        </pc:sldLayoutChg>
        <pc:sldLayoutChg chg="add del mod replId">
          <pc:chgData name="maryam kandi" userId="3dae5b15da3a7b39" providerId="Windows Live" clId="Web-{4D7AB1A2-73F0-4374-A5AF-B96C6BF3A8B1}" dt="2021-04-20T15:46:52.543" v="240"/>
          <pc:sldLayoutMkLst>
            <pc:docMk/>
            <pc:sldMasterMk cId="1517295786" sldId="2147483672"/>
            <pc:sldLayoutMk cId="575262567" sldId="2147483677"/>
          </pc:sldLayoutMkLst>
        </pc:sldLayoutChg>
        <pc:sldLayoutChg chg="add del mod replId">
          <pc:chgData name="maryam kandi" userId="3dae5b15da3a7b39" providerId="Windows Live" clId="Web-{4D7AB1A2-73F0-4374-A5AF-B96C6BF3A8B1}" dt="2021-04-20T15:46:52.543" v="240"/>
          <pc:sldLayoutMkLst>
            <pc:docMk/>
            <pc:sldMasterMk cId="1517295786" sldId="2147483672"/>
            <pc:sldLayoutMk cId="2700672402" sldId="2147483678"/>
          </pc:sldLayoutMkLst>
        </pc:sldLayoutChg>
        <pc:sldLayoutChg chg="add del mod replId">
          <pc:chgData name="maryam kandi" userId="3dae5b15da3a7b39" providerId="Windows Live" clId="Web-{4D7AB1A2-73F0-4374-A5AF-B96C6BF3A8B1}" dt="2021-04-20T15:46:52.543" v="240"/>
          <pc:sldLayoutMkLst>
            <pc:docMk/>
            <pc:sldMasterMk cId="1517295786" sldId="2147483672"/>
            <pc:sldLayoutMk cId="1912859016" sldId="2147483679"/>
          </pc:sldLayoutMkLst>
        </pc:sldLayoutChg>
        <pc:sldLayoutChg chg="add del mod replId">
          <pc:chgData name="maryam kandi" userId="3dae5b15da3a7b39" providerId="Windows Live" clId="Web-{4D7AB1A2-73F0-4374-A5AF-B96C6BF3A8B1}" dt="2021-04-20T15:46:52.543" v="240"/>
          <pc:sldLayoutMkLst>
            <pc:docMk/>
            <pc:sldMasterMk cId="1517295786" sldId="2147483672"/>
            <pc:sldLayoutMk cId="3519334937" sldId="2147483680"/>
          </pc:sldLayoutMkLst>
        </pc:sldLayoutChg>
        <pc:sldLayoutChg chg="add del mod replId">
          <pc:chgData name="maryam kandi" userId="3dae5b15da3a7b39" providerId="Windows Live" clId="Web-{4D7AB1A2-73F0-4374-A5AF-B96C6BF3A8B1}" dt="2021-04-20T15:46:52.543" v="240"/>
          <pc:sldLayoutMkLst>
            <pc:docMk/>
            <pc:sldMasterMk cId="1517295786" sldId="2147483672"/>
            <pc:sldLayoutMk cId="2861240658" sldId="2147483681"/>
          </pc:sldLayoutMkLst>
        </pc:sldLayoutChg>
        <pc:sldLayoutChg chg="add del mod replId">
          <pc:chgData name="maryam kandi" userId="3dae5b15da3a7b39" providerId="Windows Live" clId="Web-{4D7AB1A2-73F0-4374-A5AF-B96C6BF3A8B1}" dt="2021-04-20T15:46:52.543" v="240"/>
          <pc:sldLayoutMkLst>
            <pc:docMk/>
            <pc:sldMasterMk cId="1517295786" sldId="2147483672"/>
            <pc:sldLayoutMk cId="1630383467" sldId="2147483682"/>
          </pc:sldLayoutMkLst>
        </pc:sldLayoutChg>
        <pc:sldLayoutChg chg="add del mod replId">
          <pc:chgData name="maryam kandi" userId="3dae5b15da3a7b39" providerId="Windows Live" clId="Web-{4D7AB1A2-73F0-4374-A5AF-B96C6BF3A8B1}" dt="2021-04-20T15:46:52.543" v="240"/>
          <pc:sldLayoutMkLst>
            <pc:docMk/>
            <pc:sldMasterMk cId="1517295786" sldId="2147483672"/>
            <pc:sldLayoutMk cId="2893850770" sldId="2147483683"/>
          </pc:sldLayoutMkLst>
        </pc:sldLayoutChg>
      </pc:sldMasterChg>
    </pc:docChg>
  </pc:docChgLst>
  <pc:docChgLst>
    <pc:chgData name="Gihad Nesrallah" userId="8bde8390f922eb33" providerId="LiveId" clId="{A63C5F34-0272-D14E-8AE1-AE0073669E2D}"/>
    <pc:docChg chg="custSel modSld">
      <pc:chgData name="Gihad Nesrallah" userId="8bde8390f922eb33" providerId="LiveId" clId="{A63C5F34-0272-D14E-8AE1-AE0073669E2D}" dt="2021-04-11T22:55:39.281" v="186" actId="20577"/>
      <pc:docMkLst>
        <pc:docMk/>
      </pc:docMkLst>
      <pc:sldChg chg="addSp delSp modSp mod">
        <pc:chgData name="Gihad Nesrallah" userId="8bde8390f922eb33" providerId="LiveId" clId="{A63C5F34-0272-D14E-8AE1-AE0073669E2D}" dt="2021-04-11T22:55:39.281" v="186" actId="20577"/>
        <pc:sldMkLst>
          <pc:docMk/>
          <pc:sldMk cId="1414725883" sldId="256"/>
        </pc:sldMkLst>
        <pc:spChg chg="mod">
          <ac:chgData name="Gihad Nesrallah" userId="8bde8390f922eb33" providerId="LiveId" clId="{A63C5F34-0272-D14E-8AE1-AE0073669E2D}" dt="2021-04-11T22:42:20.553" v="19" actId="1076"/>
          <ac:spMkLst>
            <pc:docMk/>
            <pc:sldMk cId="1414725883" sldId="256"/>
            <ac:spMk id="4" creationId="{61734171-A701-DD48-A4FA-630F174A68B7}"/>
          </ac:spMkLst>
        </pc:spChg>
        <pc:spChg chg="add mod">
          <ac:chgData name="Gihad Nesrallah" userId="8bde8390f922eb33" providerId="LiveId" clId="{A63C5F34-0272-D14E-8AE1-AE0073669E2D}" dt="2021-04-11T22:55:39.281" v="186" actId="20577"/>
          <ac:spMkLst>
            <pc:docMk/>
            <pc:sldMk cId="1414725883" sldId="256"/>
            <ac:spMk id="9" creationId="{785FF1E0-1A5E-E44F-86A1-154B7B4A4149}"/>
          </ac:spMkLst>
        </pc:spChg>
        <pc:picChg chg="add del mod">
          <ac:chgData name="Gihad Nesrallah" userId="8bde8390f922eb33" providerId="LiveId" clId="{A63C5F34-0272-D14E-8AE1-AE0073669E2D}" dt="2021-04-11T22:41:06.433" v="3" actId="478"/>
          <ac:picMkLst>
            <pc:docMk/>
            <pc:sldMk cId="1414725883" sldId="256"/>
            <ac:picMk id="5" creationId="{A84E032D-92D1-4957-988C-442F7E4276BF}"/>
          </ac:picMkLst>
        </pc:picChg>
        <pc:picChg chg="add mod">
          <ac:chgData name="Gihad Nesrallah" userId="8bde8390f922eb33" providerId="LiveId" clId="{A63C5F34-0272-D14E-8AE1-AE0073669E2D}" dt="2021-04-11T22:41:30.410" v="8" actId="14100"/>
          <ac:picMkLst>
            <pc:docMk/>
            <pc:sldMk cId="1414725883" sldId="256"/>
            <ac:picMk id="6" creationId="{A84E032D-92D1-4957-988C-442F7E4276BF}"/>
          </ac:picMkLst>
        </pc:picChg>
        <pc:picChg chg="del">
          <ac:chgData name="Gihad Nesrallah" userId="8bde8390f922eb33" providerId="LiveId" clId="{A63C5F34-0272-D14E-8AE1-AE0073669E2D}" dt="2021-04-11T22:38:37.765" v="0" actId="478"/>
          <ac:picMkLst>
            <pc:docMk/>
            <pc:sldMk cId="1414725883" sldId="256"/>
            <ac:picMk id="7" creationId="{7E5A842A-D073-45BD-9401-6B31BF1495BE}"/>
          </ac:picMkLst>
        </pc:picChg>
        <pc:picChg chg="add mod">
          <ac:chgData name="Gihad Nesrallah" userId="8bde8390f922eb33" providerId="LiveId" clId="{A63C5F34-0272-D14E-8AE1-AE0073669E2D}" dt="2021-04-11T22:42:05.792" v="18" actId="14100"/>
          <ac:picMkLst>
            <pc:docMk/>
            <pc:sldMk cId="1414725883" sldId="256"/>
            <ac:picMk id="8" creationId="{A8469CBC-7BB6-4234-9A38-544432743156}"/>
          </ac:picMkLst>
        </pc:picChg>
      </pc:sldChg>
      <pc:sldChg chg="addSp delSp modSp mod">
        <pc:chgData name="Gihad Nesrallah" userId="8bde8390f922eb33" providerId="LiveId" clId="{A63C5F34-0272-D14E-8AE1-AE0073669E2D}" dt="2021-04-11T22:44:18.076" v="54" actId="20577"/>
        <pc:sldMkLst>
          <pc:docMk/>
          <pc:sldMk cId="3051435570" sldId="258"/>
        </pc:sldMkLst>
        <pc:spChg chg="add del mod">
          <ac:chgData name="Gihad Nesrallah" userId="8bde8390f922eb33" providerId="LiveId" clId="{A63C5F34-0272-D14E-8AE1-AE0073669E2D}" dt="2021-04-11T22:44:07.525" v="43"/>
          <ac:spMkLst>
            <pc:docMk/>
            <pc:sldMk cId="3051435570" sldId="258"/>
            <ac:spMk id="2" creationId="{29DAD1C7-5F60-F446-A25A-F20FCDA49108}"/>
          </ac:spMkLst>
        </pc:spChg>
        <pc:spChg chg="add mod">
          <ac:chgData name="Gihad Nesrallah" userId="8bde8390f922eb33" providerId="LiveId" clId="{A63C5F34-0272-D14E-8AE1-AE0073669E2D}" dt="2021-04-11T22:44:12.721" v="49" actId="20577"/>
          <ac:spMkLst>
            <pc:docMk/>
            <pc:sldMk cId="3051435570" sldId="258"/>
            <ac:spMk id="6" creationId="{32ED9215-E038-B64A-89B3-CFD54CD1DC05}"/>
          </ac:spMkLst>
        </pc:spChg>
        <pc:spChg chg="mod">
          <ac:chgData name="Gihad Nesrallah" userId="8bde8390f922eb33" providerId="LiveId" clId="{A63C5F34-0272-D14E-8AE1-AE0073669E2D}" dt="2021-04-11T22:44:18.076" v="54" actId="20577"/>
          <ac:spMkLst>
            <pc:docMk/>
            <pc:sldMk cId="3051435570" sldId="258"/>
            <ac:spMk id="8" creationId="{DFBC4418-AC4E-824B-9A31-96C32DC12113}"/>
          </ac:spMkLst>
        </pc:spChg>
        <pc:picChg chg="add mod">
          <ac:chgData name="Gihad Nesrallah" userId="8bde8390f922eb33" providerId="LiveId" clId="{A63C5F34-0272-D14E-8AE1-AE0073669E2D}" dt="2021-04-11T22:43:17.718" v="28" actId="14100"/>
          <ac:picMkLst>
            <pc:docMk/>
            <pc:sldMk cId="3051435570" sldId="258"/>
            <ac:picMk id="4" creationId="{C38C7EF2-5DA3-4981-9F5B-D65145D199C6}"/>
          </ac:picMkLst>
        </pc:picChg>
        <pc:picChg chg="del">
          <ac:chgData name="Gihad Nesrallah" userId="8bde8390f922eb33" providerId="LiveId" clId="{A63C5F34-0272-D14E-8AE1-AE0073669E2D}" dt="2021-04-11T22:42:56.882" v="25" actId="478"/>
          <ac:picMkLst>
            <pc:docMk/>
            <pc:sldMk cId="3051435570" sldId="258"/>
            <ac:picMk id="5" creationId="{C08731A9-8D1A-4E9A-A961-AB12974BBD45}"/>
          </ac:picMkLst>
        </pc:picChg>
        <pc:picChg chg="add mod">
          <ac:chgData name="Gihad Nesrallah" userId="8bde8390f922eb33" providerId="LiveId" clId="{A63C5F34-0272-D14E-8AE1-AE0073669E2D}" dt="2021-04-11T22:43:53.089" v="38" actId="14100"/>
          <ac:picMkLst>
            <pc:docMk/>
            <pc:sldMk cId="3051435570" sldId="258"/>
            <ac:picMk id="7" creationId="{40016404-12CC-6442-B9F4-2BF8F51CB148}"/>
          </ac:picMkLst>
        </pc:picChg>
      </pc:sldChg>
      <pc:sldChg chg="addSp delSp modSp mod">
        <pc:chgData name="Gihad Nesrallah" userId="8bde8390f922eb33" providerId="LiveId" clId="{A63C5F34-0272-D14E-8AE1-AE0073669E2D}" dt="2021-04-11T22:55:10.720" v="182" actId="20577"/>
        <pc:sldMkLst>
          <pc:docMk/>
          <pc:sldMk cId="1018678779" sldId="259"/>
        </pc:sldMkLst>
        <pc:spChg chg="mod">
          <ac:chgData name="Gihad Nesrallah" userId="8bde8390f922eb33" providerId="LiveId" clId="{A63C5F34-0272-D14E-8AE1-AE0073669E2D}" dt="2021-04-11T22:55:10.720" v="182" actId="20577"/>
          <ac:spMkLst>
            <pc:docMk/>
            <pc:sldMk cId="1018678779" sldId="259"/>
            <ac:spMk id="4" creationId="{61734171-A701-DD48-A4FA-630F174A68B7}"/>
          </ac:spMkLst>
        </pc:spChg>
        <pc:picChg chg="del">
          <ac:chgData name="Gihad Nesrallah" userId="8bde8390f922eb33" providerId="LiveId" clId="{A63C5F34-0272-D14E-8AE1-AE0073669E2D}" dt="2021-04-11T22:44:45.011" v="55" actId="478"/>
          <ac:picMkLst>
            <pc:docMk/>
            <pc:sldMk cId="1018678779" sldId="259"/>
            <ac:picMk id="3" creationId="{24466872-B58B-4DF8-B1F9-6ADF253F9C88}"/>
          </ac:picMkLst>
        </pc:picChg>
        <pc:picChg chg="add mod">
          <ac:chgData name="Gihad Nesrallah" userId="8bde8390f922eb33" providerId="LiveId" clId="{A63C5F34-0272-D14E-8AE1-AE0073669E2D}" dt="2021-04-11T22:44:53.245" v="57" actId="1076"/>
          <ac:picMkLst>
            <pc:docMk/>
            <pc:sldMk cId="1018678779" sldId="259"/>
            <ac:picMk id="5" creationId="{F3CB545A-7855-46B0-ACE8-FE8A68E07543}"/>
          </ac:picMkLst>
        </pc:picChg>
      </pc:sldChg>
      <pc:sldChg chg="addSp delSp modSp mod">
        <pc:chgData name="Gihad Nesrallah" userId="8bde8390f922eb33" providerId="LiveId" clId="{A63C5F34-0272-D14E-8AE1-AE0073669E2D}" dt="2021-04-11T22:46:34.578" v="75" actId="20577"/>
        <pc:sldMkLst>
          <pc:docMk/>
          <pc:sldMk cId="3360400957" sldId="260"/>
        </pc:sldMkLst>
        <pc:spChg chg="mod">
          <ac:chgData name="Gihad Nesrallah" userId="8bde8390f922eb33" providerId="LiveId" clId="{A63C5F34-0272-D14E-8AE1-AE0073669E2D}" dt="2021-04-11T22:46:34.578" v="75" actId="20577"/>
          <ac:spMkLst>
            <pc:docMk/>
            <pc:sldMk cId="3360400957" sldId="260"/>
            <ac:spMk id="4" creationId="{61734171-A701-DD48-A4FA-630F174A68B7}"/>
          </ac:spMkLst>
        </pc:spChg>
        <pc:picChg chg="del">
          <ac:chgData name="Gihad Nesrallah" userId="8bde8390f922eb33" providerId="LiveId" clId="{A63C5F34-0272-D14E-8AE1-AE0073669E2D}" dt="2021-04-11T22:45:39.531" v="58" actId="478"/>
          <ac:picMkLst>
            <pc:docMk/>
            <pc:sldMk cId="3360400957" sldId="260"/>
            <ac:picMk id="3" creationId="{4AC6E4AA-16C3-4C1E-9A90-B87303C5EE3B}"/>
          </ac:picMkLst>
        </pc:picChg>
        <pc:picChg chg="add del mod">
          <ac:chgData name="Gihad Nesrallah" userId="8bde8390f922eb33" providerId="LiveId" clId="{A63C5F34-0272-D14E-8AE1-AE0073669E2D}" dt="2021-04-11T22:46:21.359" v="72" actId="478"/>
          <ac:picMkLst>
            <pc:docMk/>
            <pc:sldMk cId="3360400957" sldId="260"/>
            <ac:picMk id="5" creationId="{EC066133-ADF6-5049-91C1-A68719973B87}"/>
          </ac:picMkLst>
        </pc:picChg>
        <pc:picChg chg="add mod">
          <ac:chgData name="Gihad Nesrallah" userId="8bde8390f922eb33" providerId="LiveId" clId="{A63C5F34-0272-D14E-8AE1-AE0073669E2D}" dt="2021-04-11T22:46:16.443" v="71" actId="14100"/>
          <ac:picMkLst>
            <pc:docMk/>
            <pc:sldMk cId="3360400957" sldId="260"/>
            <ac:picMk id="6" creationId="{C9F07AB0-97FD-1A45-8658-907F320E807B}"/>
          </ac:picMkLst>
        </pc:picChg>
      </pc:sldChg>
      <pc:sldChg chg="addSp delSp modSp mod">
        <pc:chgData name="Gihad Nesrallah" userId="8bde8390f922eb33" providerId="LiveId" clId="{A63C5F34-0272-D14E-8AE1-AE0073669E2D}" dt="2021-04-11T22:48:58.775" v="119" actId="1076"/>
        <pc:sldMkLst>
          <pc:docMk/>
          <pc:sldMk cId="2291767739" sldId="261"/>
        </pc:sldMkLst>
        <pc:spChg chg="mod">
          <ac:chgData name="Gihad Nesrallah" userId="8bde8390f922eb33" providerId="LiveId" clId="{A63C5F34-0272-D14E-8AE1-AE0073669E2D}" dt="2021-04-11T22:48:31.254" v="108" actId="20577"/>
          <ac:spMkLst>
            <pc:docMk/>
            <pc:sldMk cId="2291767739" sldId="261"/>
            <ac:spMk id="4" creationId="{61734171-A701-DD48-A4FA-630F174A68B7}"/>
          </ac:spMkLst>
        </pc:spChg>
        <pc:spChg chg="mod">
          <ac:chgData name="Gihad Nesrallah" userId="8bde8390f922eb33" providerId="LiveId" clId="{A63C5F34-0272-D14E-8AE1-AE0073669E2D}" dt="2021-04-11T22:48:36.679" v="115" actId="20577"/>
          <ac:spMkLst>
            <pc:docMk/>
            <pc:sldMk cId="2291767739" sldId="261"/>
            <ac:spMk id="7" creationId="{2BA466B8-1321-AE4B-A475-D11804BC1F80}"/>
          </ac:spMkLst>
        </pc:spChg>
        <pc:picChg chg="add mod">
          <ac:chgData name="Gihad Nesrallah" userId="8bde8390f922eb33" providerId="LiveId" clId="{A63C5F34-0272-D14E-8AE1-AE0073669E2D}" dt="2021-04-11T22:47:48.392" v="79" actId="1076"/>
          <ac:picMkLst>
            <pc:docMk/>
            <pc:sldMk cId="2291767739" sldId="261"/>
            <ac:picMk id="6" creationId="{9A8A1682-18E0-E840-8B54-36C2672B1B67}"/>
          </ac:picMkLst>
        </pc:picChg>
        <pc:picChg chg="add mod">
          <ac:chgData name="Gihad Nesrallah" userId="8bde8390f922eb33" providerId="LiveId" clId="{A63C5F34-0272-D14E-8AE1-AE0073669E2D}" dt="2021-04-11T22:48:58.775" v="119" actId="1076"/>
          <ac:picMkLst>
            <pc:docMk/>
            <pc:sldMk cId="2291767739" sldId="261"/>
            <ac:picMk id="8" creationId="{B5179650-16F7-7141-9BB1-F2248CC56B10}"/>
          </ac:picMkLst>
        </pc:picChg>
        <pc:picChg chg="del">
          <ac:chgData name="Gihad Nesrallah" userId="8bde8390f922eb33" providerId="LiveId" clId="{A63C5F34-0272-D14E-8AE1-AE0073669E2D}" dt="2021-04-11T22:47:30.223" v="77" actId="478"/>
          <ac:picMkLst>
            <pc:docMk/>
            <pc:sldMk cId="2291767739" sldId="261"/>
            <ac:picMk id="10" creationId="{F2EC4A30-675C-4C7D-8945-43C2CC8D32DE}"/>
          </ac:picMkLst>
        </pc:picChg>
        <pc:picChg chg="del">
          <ac:chgData name="Gihad Nesrallah" userId="8bde8390f922eb33" providerId="LiveId" clId="{A63C5F34-0272-D14E-8AE1-AE0073669E2D}" dt="2021-04-11T22:47:27.175" v="76" actId="478"/>
          <ac:picMkLst>
            <pc:docMk/>
            <pc:sldMk cId="2291767739" sldId="261"/>
            <ac:picMk id="12" creationId="{C5D5672C-F552-4EBC-BA18-B96E5439CAC7}"/>
          </ac:picMkLst>
        </pc:picChg>
      </pc:sldChg>
      <pc:sldChg chg="addSp delSp modSp mod">
        <pc:chgData name="Gihad Nesrallah" userId="8bde8390f922eb33" providerId="LiveId" clId="{A63C5F34-0272-D14E-8AE1-AE0073669E2D}" dt="2021-04-11T22:54:51.489" v="175" actId="20577"/>
        <pc:sldMkLst>
          <pc:docMk/>
          <pc:sldMk cId="1841772963" sldId="264"/>
        </pc:sldMkLst>
        <pc:spChg chg="mod">
          <ac:chgData name="Gihad Nesrallah" userId="8bde8390f922eb33" providerId="LiveId" clId="{A63C5F34-0272-D14E-8AE1-AE0073669E2D}" dt="2021-04-11T22:54:34.208" v="156" actId="20577"/>
          <ac:spMkLst>
            <pc:docMk/>
            <pc:sldMk cId="1841772963" sldId="264"/>
            <ac:spMk id="4" creationId="{D8713651-F972-E44A-8921-6616912E36DD}"/>
          </ac:spMkLst>
        </pc:spChg>
        <pc:spChg chg="mod">
          <ac:chgData name="Gihad Nesrallah" userId="8bde8390f922eb33" providerId="LiveId" clId="{A63C5F34-0272-D14E-8AE1-AE0073669E2D}" dt="2021-04-11T22:54:51.489" v="175" actId="20577"/>
          <ac:spMkLst>
            <pc:docMk/>
            <pc:sldMk cId="1841772963" sldId="264"/>
            <ac:spMk id="7" creationId="{2BA466B8-1321-AE4B-A475-D11804BC1F80}"/>
          </ac:spMkLst>
        </pc:spChg>
        <pc:picChg chg="del">
          <ac:chgData name="Gihad Nesrallah" userId="8bde8390f922eb33" providerId="LiveId" clId="{A63C5F34-0272-D14E-8AE1-AE0073669E2D}" dt="2021-04-11T22:51:37.681" v="121" actId="478"/>
          <ac:picMkLst>
            <pc:docMk/>
            <pc:sldMk cId="1841772963" sldId="264"/>
            <ac:picMk id="3" creationId="{EE8EB540-F37D-47A7-963D-A35A2F9E2433}"/>
          </ac:picMkLst>
        </pc:picChg>
        <pc:picChg chg="del">
          <ac:chgData name="Gihad Nesrallah" userId="8bde8390f922eb33" providerId="LiveId" clId="{A63C5F34-0272-D14E-8AE1-AE0073669E2D}" dt="2021-04-11T22:51:36.332" v="120" actId="478"/>
          <ac:picMkLst>
            <pc:docMk/>
            <pc:sldMk cId="1841772963" sldId="264"/>
            <ac:picMk id="6" creationId="{2D73F7BF-7BC1-49CE-BEEB-A41BD6E1E8FC}"/>
          </ac:picMkLst>
        </pc:picChg>
        <pc:picChg chg="add mod">
          <ac:chgData name="Gihad Nesrallah" userId="8bde8390f922eb33" providerId="LiveId" clId="{A63C5F34-0272-D14E-8AE1-AE0073669E2D}" dt="2021-04-11T22:52:00.938" v="126" actId="1076"/>
          <ac:picMkLst>
            <pc:docMk/>
            <pc:sldMk cId="1841772963" sldId="264"/>
            <ac:picMk id="8" creationId="{5718022E-2A8D-4F99-AAB3-8CF41A25ABB2}"/>
          </ac:picMkLst>
        </pc:picChg>
        <pc:picChg chg="add mod">
          <ac:chgData name="Gihad Nesrallah" userId="8bde8390f922eb33" providerId="LiveId" clId="{A63C5F34-0272-D14E-8AE1-AE0073669E2D}" dt="2021-04-11T22:51:56.514" v="125" actId="1076"/>
          <ac:picMkLst>
            <pc:docMk/>
            <pc:sldMk cId="1841772963" sldId="264"/>
            <ac:picMk id="9" creationId="{509B3A4E-8C56-154C-BE78-F78FD2A8E8FE}"/>
          </ac:picMkLst>
        </pc:picChg>
      </pc:sldChg>
      <pc:sldChg chg="addSp delSp modSp mod">
        <pc:chgData name="Gihad Nesrallah" userId="8bde8390f922eb33" providerId="LiveId" clId="{A63C5F34-0272-D14E-8AE1-AE0073669E2D}" dt="2021-04-11T22:54:21.953" v="149" actId="20577"/>
        <pc:sldMkLst>
          <pc:docMk/>
          <pc:sldMk cId="2965136875" sldId="265"/>
        </pc:sldMkLst>
        <pc:spChg chg="mod">
          <ac:chgData name="Gihad Nesrallah" userId="8bde8390f922eb33" providerId="LiveId" clId="{A63C5F34-0272-D14E-8AE1-AE0073669E2D}" dt="2021-04-11T22:54:09.547" v="140" actId="20577"/>
          <ac:spMkLst>
            <pc:docMk/>
            <pc:sldMk cId="2965136875" sldId="265"/>
            <ac:spMk id="4" creationId="{D8713651-F972-E44A-8921-6616912E36DD}"/>
          </ac:spMkLst>
        </pc:spChg>
        <pc:spChg chg="mod">
          <ac:chgData name="Gihad Nesrallah" userId="8bde8390f922eb33" providerId="LiveId" clId="{A63C5F34-0272-D14E-8AE1-AE0073669E2D}" dt="2021-04-11T22:54:21.953" v="149" actId="20577"/>
          <ac:spMkLst>
            <pc:docMk/>
            <pc:sldMk cId="2965136875" sldId="265"/>
            <ac:spMk id="7" creationId="{2BA466B8-1321-AE4B-A475-D11804BC1F80}"/>
          </ac:spMkLst>
        </pc:spChg>
        <pc:picChg chg="del">
          <ac:chgData name="Gihad Nesrallah" userId="8bde8390f922eb33" providerId="LiveId" clId="{A63C5F34-0272-D14E-8AE1-AE0073669E2D}" dt="2021-04-11T22:52:33.484" v="129" actId="478"/>
          <ac:picMkLst>
            <pc:docMk/>
            <pc:sldMk cId="2965136875" sldId="265"/>
            <ac:picMk id="5" creationId="{A00B477B-BC40-46A9-80BE-1C87B02BF773}"/>
          </ac:picMkLst>
        </pc:picChg>
        <pc:picChg chg="add mod">
          <ac:chgData name="Gihad Nesrallah" userId="8bde8390f922eb33" providerId="LiveId" clId="{A63C5F34-0272-D14E-8AE1-AE0073669E2D}" dt="2021-04-11T22:52:59.869" v="131" actId="1076"/>
          <ac:picMkLst>
            <pc:docMk/>
            <pc:sldMk cId="2965136875" sldId="265"/>
            <ac:picMk id="6" creationId="{3870F5D5-8D95-4727-A849-B4D204CEC692}"/>
          </ac:picMkLst>
        </pc:picChg>
        <pc:picChg chg="add mod">
          <ac:chgData name="Gihad Nesrallah" userId="8bde8390f922eb33" providerId="LiveId" clId="{A63C5F34-0272-D14E-8AE1-AE0073669E2D}" dt="2021-04-11T22:53:51.382" v="133" actId="1076"/>
          <ac:picMkLst>
            <pc:docMk/>
            <pc:sldMk cId="2965136875" sldId="265"/>
            <ac:picMk id="8" creationId="{57985E71-2B82-4EBC-B503-81936D4C997D}"/>
          </ac:picMkLst>
        </pc:picChg>
        <pc:picChg chg="del">
          <ac:chgData name="Gihad Nesrallah" userId="8bde8390f922eb33" providerId="LiveId" clId="{A63C5F34-0272-D14E-8AE1-AE0073669E2D}" dt="2021-04-11T22:52:32.374" v="128" actId="478"/>
          <ac:picMkLst>
            <pc:docMk/>
            <pc:sldMk cId="2965136875" sldId="265"/>
            <ac:picMk id="11" creationId="{5A1E8D24-DE46-49F7-A735-D665A6742999}"/>
          </ac:picMkLst>
        </pc:picChg>
      </pc:sldChg>
    </pc:docChg>
  </pc:docChgLst>
  <pc:docChgLst>
    <pc:chgData name="Gihad Nesrallah" userId="8bde8390f922eb33" providerId="LiveId" clId="{74DFDD05-2C92-4AC4-8249-14E4822B556E}"/>
    <pc:docChg chg="delSld">
      <pc:chgData name="Gihad Nesrallah" userId="8bde8390f922eb33" providerId="LiveId" clId="{74DFDD05-2C92-4AC4-8249-14E4822B556E}" dt="2020-11-12T18:09:30.240" v="1" actId="47"/>
      <pc:docMkLst>
        <pc:docMk/>
      </pc:docMkLst>
      <pc:sldChg chg="del">
        <pc:chgData name="Gihad Nesrallah" userId="8bde8390f922eb33" providerId="LiveId" clId="{74DFDD05-2C92-4AC4-8249-14E4822B556E}" dt="2020-11-12T18:09:28.942" v="0" actId="47"/>
        <pc:sldMkLst>
          <pc:docMk/>
          <pc:sldMk cId="2819719065" sldId="278"/>
        </pc:sldMkLst>
      </pc:sldChg>
      <pc:sldChg chg="del">
        <pc:chgData name="Gihad Nesrallah" userId="8bde8390f922eb33" providerId="LiveId" clId="{74DFDD05-2C92-4AC4-8249-14E4822B556E}" dt="2020-11-12T18:09:28.942" v="0" actId="47"/>
        <pc:sldMkLst>
          <pc:docMk/>
          <pc:sldMk cId="3234178147" sldId="279"/>
        </pc:sldMkLst>
      </pc:sldChg>
      <pc:sldChg chg="del">
        <pc:chgData name="Gihad Nesrallah" userId="8bde8390f922eb33" providerId="LiveId" clId="{74DFDD05-2C92-4AC4-8249-14E4822B556E}" dt="2020-11-12T18:09:28.942" v="0" actId="47"/>
        <pc:sldMkLst>
          <pc:docMk/>
          <pc:sldMk cId="3131756451" sldId="280"/>
        </pc:sldMkLst>
      </pc:sldChg>
      <pc:sldChg chg="del">
        <pc:chgData name="Gihad Nesrallah" userId="8bde8390f922eb33" providerId="LiveId" clId="{74DFDD05-2C92-4AC4-8249-14E4822B556E}" dt="2020-11-12T18:09:28.942" v="0" actId="47"/>
        <pc:sldMkLst>
          <pc:docMk/>
          <pc:sldMk cId="1934494007" sldId="281"/>
        </pc:sldMkLst>
      </pc:sldChg>
      <pc:sldChg chg="del">
        <pc:chgData name="Gihad Nesrallah" userId="8bde8390f922eb33" providerId="LiveId" clId="{74DFDD05-2C92-4AC4-8249-14E4822B556E}" dt="2020-11-12T18:09:28.942" v="0" actId="47"/>
        <pc:sldMkLst>
          <pc:docMk/>
          <pc:sldMk cId="2344592930" sldId="282"/>
        </pc:sldMkLst>
      </pc:sldChg>
      <pc:sldChg chg="del">
        <pc:chgData name="Gihad Nesrallah" userId="8bde8390f922eb33" providerId="LiveId" clId="{74DFDD05-2C92-4AC4-8249-14E4822B556E}" dt="2020-11-12T18:09:28.942" v="0" actId="47"/>
        <pc:sldMkLst>
          <pc:docMk/>
          <pc:sldMk cId="1276411317" sldId="283"/>
        </pc:sldMkLst>
      </pc:sldChg>
      <pc:sldChg chg="del">
        <pc:chgData name="Gihad Nesrallah" userId="8bde8390f922eb33" providerId="LiveId" clId="{74DFDD05-2C92-4AC4-8249-14E4822B556E}" dt="2020-11-12T18:09:28.942" v="0" actId="47"/>
        <pc:sldMkLst>
          <pc:docMk/>
          <pc:sldMk cId="441005186" sldId="284"/>
        </pc:sldMkLst>
      </pc:sldChg>
      <pc:sldChg chg="del">
        <pc:chgData name="Gihad Nesrallah" userId="8bde8390f922eb33" providerId="LiveId" clId="{74DFDD05-2C92-4AC4-8249-14E4822B556E}" dt="2020-11-12T18:09:28.942" v="0" actId="47"/>
        <pc:sldMkLst>
          <pc:docMk/>
          <pc:sldMk cId="2652513528" sldId="285"/>
        </pc:sldMkLst>
      </pc:sldChg>
      <pc:sldChg chg="del">
        <pc:chgData name="Gihad Nesrallah" userId="8bde8390f922eb33" providerId="LiveId" clId="{74DFDD05-2C92-4AC4-8249-14E4822B556E}" dt="2020-11-12T18:09:28.942" v="0" actId="47"/>
        <pc:sldMkLst>
          <pc:docMk/>
          <pc:sldMk cId="1527119579" sldId="286"/>
        </pc:sldMkLst>
      </pc:sldChg>
      <pc:sldChg chg="del">
        <pc:chgData name="Gihad Nesrallah" userId="8bde8390f922eb33" providerId="LiveId" clId="{74DFDD05-2C92-4AC4-8249-14E4822B556E}" dt="2020-11-12T18:09:28.942" v="0" actId="47"/>
        <pc:sldMkLst>
          <pc:docMk/>
          <pc:sldMk cId="665911096" sldId="287"/>
        </pc:sldMkLst>
      </pc:sldChg>
      <pc:sldChg chg="del">
        <pc:chgData name="Gihad Nesrallah" userId="8bde8390f922eb33" providerId="LiveId" clId="{74DFDD05-2C92-4AC4-8249-14E4822B556E}" dt="2020-11-12T18:09:28.942" v="0" actId="47"/>
        <pc:sldMkLst>
          <pc:docMk/>
          <pc:sldMk cId="3678360659" sldId="288"/>
        </pc:sldMkLst>
      </pc:sldChg>
      <pc:sldChg chg="del">
        <pc:chgData name="Gihad Nesrallah" userId="8bde8390f922eb33" providerId="LiveId" clId="{74DFDD05-2C92-4AC4-8249-14E4822B556E}" dt="2020-11-12T18:09:28.942" v="0" actId="47"/>
        <pc:sldMkLst>
          <pc:docMk/>
          <pc:sldMk cId="3602407774" sldId="289"/>
        </pc:sldMkLst>
      </pc:sldChg>
      <pc:sldChg chg="del">
        <pc:chgData name="Gihad Nesrallah" userId="8bde8390f922eb33" providerId="LiveId" clId="{74DFDD05-2C92-4AC4-8249-14E4822B556E}" dt="2020-11-12T18:09:28.942" v="0" actId="47"/>
        <pc:sldMkLst>
          <pc:docMk/>
          <pc:sldMk cId="1468419268" sldId="290"/>
        </pc:sldMkLst>
      </pc:sldChg>
      <pc:sldChg chg="del">
        <pc:chgData name="Gihad Nesrallah" userId="8bde8390f922eb33" providerId="LiveId" clId="{74DFDD05-2C92-4AC4-8249-14E4822B556E}" dt="2020-11-12T18:09:28.942" v="0" actId="47"/>
        <pc:sldMkLst>
          <pc:docMk/>
          <pc:sldMk cId="1047655378" sldId="291"/>
        </pc:sldMkLst>
      </pc:sldChg>
      <pc:sldChg chg="del">
        <pc:chgData name="Gihad Nesrallah" userId="8bde8390f922eb33" providerId="LiveId" clId="{74DFDD05-2C92-4AC4-8249-14E4822B556E}" dt="2020-11-12T18:09:28.942" v="0" actId="47"/>
        <pc:sldMkLst>
          <pc:docMk/>
          <pc:sldMk cId="1681530951" sldId="292"/>
        </pc:sldMkLst>
      </pc:sldChg>
      <pc:sldChg chg="del">
        <pc:chgData name="Gihad Nesrallah" userId="8bde8390f922eb33" providerId="LiveId" clId="{74DFDD05-2C92-4AC4-8249-14E4822B556E}" dt="2020-11-12T18:09:28.942" v="0" actId="47"/>
        <pc:sldMkLst>
          <pc:docMk/>
          <pc:sldMk cId="3031992322" sldId="293"/>
        </pc:sldMkLst>
      </pc:sldChg>
      <pc:sldChg chg="del">
        <pc:chgData name="Gihad Nesrallah" userId="8bde8390f922eb33" providerId="LiveId" clId="{74DFDD05-2C92-4AC4-8249-14E4822B556E}" dt="2020-11-12T18:09:30.240" v="1" actId="47"/>
        <pc:sldMkLst>
          <pc:docMk/>
          <pc:sldMk cId="518499756" sldId="294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A343A9-F347-7644-B25D-E0367CA4F0C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2DC952F-0331-6543-8137-D55E1765E74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27A6E5-363C-7E4D-8C20-D29F2DE1B6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39E63-99AD-C843-9811-51CAF6A2C5C8}" type="datetimeFigureOut">
              <a:rPr lang="en-US" smtClean="0"/>
              <a:t>6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77FB82-AC5E-0748-A7E8-56DB511784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84780E-0469-694E-8EC8-4E1797339B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1B187-4CA3-C340-A86A-76A0A79CEF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682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26DF82-6CBC-954A-8E99-D0C1503E24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BB9DCC8-6F62-9D4F-A383-66A3120B1D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EA4BE9-A325-E747-8F46-9E4C09F604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39E63-99AD-C843-9811-51CAF6A2C5C8}" type="datetimeFigureOut">
              <a:rPr lang="en-US" smtClean="0"/>
              <a:t>6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70F3A5-FB1B-4549-B159-1E48913B2C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6FF2B2-FEA9-134B-88E6-D5964806E2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1B187-4CA3-C340-A86A-76A0A79CEF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84447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75A05D2-05D5-044B-BD21-3E8269B4DD1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F9BC7A2-15CC-7844-8A59-D454081A8A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DEC5F6-95AC-0044-871D-EE10FCF322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39E63-99AD-C843-9811-51CAF6A2C5C8}" type="datetimeFigureOut">
              <a:rPr lang="en-US" smtClean="0"/>
              <a:t>6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B3A536-5528-B642-8341-709F8EC6CB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A9AE73-2005-664A-9E6C-2B21A3F59E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1B187-4CA3-C340-A86A-76A0A79CEF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39923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5F1AC8-833A-A14E-A3AA-2BE7C9A5C1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FC3652-9A09-E54E-81B5-173C31DA4F5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F0D053-42E7-C649-815A-EEA4906FA1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39E63-99AD-C843-9811-51CAF6A2C5C8}" type="datetimeFigureOut">
              <a:rPr lang="en-US" smtClean="0"/>
              <a:t>6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738F2B-6FF1-674B-B79D-FACE4C5ACB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308261-45C2-7346-A2F0-38EBBE0E2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1B187-4CA3-C340-A86A-76A0A79CEF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42968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8E1447-C429-FA40-B3BF-6C61BCB107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706FC36-6D8F-FF48-A7C3-8691D1105D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191138-7A7C-5146-844C-AA5DED6104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39E63-99AD-C843-9811-51CAF6A2C5C8}" type="datetimeFigureOut">
              <a:rPr lang="en-US" smtClean="0"/>
              <a:t>6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B5483D-CCD6-114C-92CB-22A8DF4044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C78CA8-BFC9-2540-8F18-4A35E8E8A0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1B187-4CA3-C340-A86A-76A0A79CEF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1357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ACFF40-5520-0B45-A436-6F98ABD1FB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86EDE4-A743-1A4E-A586-403548C34C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49598E9-21A3-E94A-874A-3F85F7D10C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FBB8CF-AAD2-224D-AD6C-E977417300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39E63-99AD-C843-9811-51CAF6A2C5C8}" type="datetimeFigureOut">
              <a:rPr lang="en-US" smtClean="0"/>
              <a:t>6/26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9DEEB83-A8AE-D64C-B116-9074FC6AA1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0A118FC-5EA5-0C4D-BBD7-724FFDA1F7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1B187-4CA3-C340-A86A-76A0A79CEF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13390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958F8E-5BF0-934E-B5AA-715437AAD9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BBABEC8-944D-684A-83B2-2286117263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EF619BE-7D1A-DC48-AF60-722557F6EC9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A648DCA-3EAD-A343-87F3-288919E8757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A2F7638-3C19-2B43-B271-B081CA87607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D980150-0546-CF44-9F7C-E4B8EFD12C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39E63-99AD-C843-9811-51CAF6A2C5C8}" type="datetimeFigureOut">
              <a:rPr lang="en-US" smtClean="0"/>
              <a:t>6/26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AFBAE94-9DA0-A648-A8F4-9F2E122802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0F5DB29-BF8F-E34F-94CF-7673500F7C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1B187-4CA3-C340-A86A-76A0A79CEF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32967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A091E1-104F-CA47-8BAC-F355022069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1D296AD-1824-F442-B93E-4749ADCD75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39E63-99AD-C843-9811-51CAF6A2C5C8}" type="datetimeFigureOut">
              <a:rPr lang="en-US" smtClean="0"/>
              <a:t>6/26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0D4ED37-6E62-124E-BB88-0B1F06B9DD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D3D2D3A-AE77-5D45-9858-091C1B72AE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1B187-4CA3-C340-A86A-76A0A79CEF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01037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347E28B-F958-3E4A-BF68-8417EC47A0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39E63-99AD-C843-9811-51CAF6A2C5C8}" type="datetimeFigureOut">
              <a:rPr lang="en-US" smtClean="0"/>
              <a:t>6/26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70F2BAA-7DEC-6848-8454-055544CA14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10A1EF2-8C85-E34E-8BA8-1C2CB9DAB8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1B187-4CA3-C340-A86A-76A0A79CEF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6945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958B77-696C-0B40-BD3F-5B491A705E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27FDCA-2A97-7B4B-9458-0E8587ED878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0597FFF-DB43-0245-8A04-0EBBDC7D40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BC0771-8A6B-4641-86EE-B689728EEB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39E63-99AD-C843-9811-51CAF6A2C5C8}" type="datetimeFigureOut">
              <a:rPr lang="en-US" smtClean="0"/>
              <a:t>6/26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2F3DF7-A130-2F45-B1D4-741CCDBDAD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C8FD410-DE30-784A-9133-2FC6B41DF7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1B187-4CA3-C340-A86A-76A0A79CEF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50972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6D4AE7-FF02-D94A-8214-2DF7FCA3C7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D798515-F358-D84B-B0B3-4B1ACC571BA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F467547-AA3A-AD40-B689-1546F346DC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D6C5EC-135C-C14A-A30F-88D4FEA54F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39E63-99AD-C843-9811-51CAF6A2C5C8}" type="datetimeFigureOut">
              <a:rPr lang="en-US" smtClean="0"/>
              <a:t>6/26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BCFCF9-43BB-0B49-961F-E5C7D0A31A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51BAAFD-F41D-B042-8766-CCD4A0335A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1B187-4CA3-C340-A86A-76A0A79CEF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70664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2170F44-F060-7D40-9C74-0057D270AF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DCB6D5D-40E2-AF4C-98B0-CEBA9EBC82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9B112B-4E20-2F45-BECE-76EA08D6347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439E63-99AD-C843-9811-51CAF6A2C5C8}" type="datetimeFigureOut">
              <a:rPr lang="en-US" smtClean="0"/>
              <a:t>6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EC832D-4E75-3F42-87D6-673E511A25F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1FF52C-9637-D545-BFA2-9C1836ACA78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01B187-4CA3-C340-A86A-76A0A79CEF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04537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4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4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4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4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4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4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4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4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4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4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4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4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4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4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4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4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4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61734171-A701-DD48-A4FA-630F174A68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77870" y="2730324"/>
            <a:ext cx="10515600" cy="585217"/>
          </a:xfrm>
        </p:spPr>
        <p:txBody>
          <a:bodyPr>
            <a:normAutofit/>
          </a:bodyPr>
          <a:lstStyle/>
          <a:p>
            <a:r>
              <a:rPr lang="en-US" sz="2000" dirty="0"/>
              <a:t>Figure 1a. Forest plot – all-cause mortality (</a:t>
            </a:r>
            <a:r>
              <a:rPr lang="en-US" sz="2000">
                <a:ea typeface="+mj-lt"/>
                <a:cs typeface="+mj-lt"/>
              </a:rPr>
              <a:t>number of deaths from any cause</a:t>
            </a:r>
            <a:r>
              <a:rPr lang="en-US" sz="2000"/>
              <a:t>) - RS.</a:t>
            </a:r>
          </a:p>
        </p:txBody>
      </p:sp>
      <p:sp>
        <p:nvSpPr>
          <p:cNvPr id="9" name="Title 3">
            <a:extLst>
              <a:ext uri="{FF2B5EF4-FFF2-40B4-BE49-F238E27FC236}">
                <a16:creationId xmlns:a16="http://schemas.microsoft.com/office/drawing/2014/main" id="{785FF1E0-1A5E-E44F-86A1-154B7B4A4149}"/>
              </a:ext>
            </a:extLst>
          </p:cNvPr>
          <p:cNvSpPr txBox="1">
            <a:spLocks/>
          </p:cNvSpPr>
          <p:nvPr/>
        </p:nvSpPr>
        <p:spPr>
          <a:xfrm>
            <a:off x="177870" y="6123269"/>
            <a:ext cx="10515600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/>
              <a:t>Figure 1b. Forest plot – all-cause mortality (</a:t>
            </a:r>
            <a:r>
              <a:rPr lang="en-US" sz="2000">
                <a:ea typeface="+mj-lt"/>
                <a:cs typeface="+mj-lt"/>
              </a:rPr>
              <a:t>number of deaths from any cause</a:t>
            </a:r>
            <a:r>
              <a:rPr lang="en-US" sz="2000"/>
              <a:t>) - NRS.</a:t>
            </a:r>
          </a:p>
        </p:txBody>
      </p:sp>
      <p:pic>
        <p:nvPicPr>
          <p:cNvPr id="2" name="Picture 2" descr="Text&#10;&#10;Description automatically generated">
            <a:extLst>
              <a:ext uri="{FF2B5EF4-FFF2-40B4-BE49-F238E27FC236}">
                <a16:creationId xmlns:a16="http://schemas.microsoft.com/office/drawing/2014/main" id="{F3FA17EA-69C8-46B8-A6B3-F42A2DDD007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1" y="107137"/>
            <a:ext cx="7588525" cy="2742620"/>
          </a:xfrm>
          <a:prstGeom prst="rect">
            <a:avLst/>
          </a:prstGeom>
        </p:spPr>
      </p:pic>
      <p:pic>
        <p:nvPicPr>
          <p:cNvPr id="3" name="Picture 4" descr="A picture containing chart&#10;&#10;Description automatically generated">
            <a:extLst>
              <a:ext uri="{FF2B5EF4-FFF2-40B4-BE49-F238E27FC236}">
                <a16:creationId xmlns:a16="http://schemas.microsoft.com/office/drawing/2014/main" id="{3CDD7378-3C54-405F-8627-0916966E4D8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2901" y="3307243"/>
            <a:ext cx="7737610" cy="28111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1472588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61734171-A701-DD48-A4FA-630F174A68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1499" y="4216348"/>
            <a:ext cx="10515600" cy="585217"/>
          </a:xfrm>
        </p:spPr>
        <p:txBody>
          <a:bodyPr>
            <a:normAutofit/>
          </a:bodyPr>
          <a:lstStyle/>
          <a:p>
            <a:r>
              <a:rPr lang="en-US" sz="2000"/>
              <a:t>Figure 10. Forest plot – </a:t>
            </a:r>
            <a:r>
              <a:rPr lang="en-US" sz="2000">
                <a:ea typeface="+mj-lt"/>
                <a:cs typeface="+mj-lt"/>
              </a:rPr>
              <a:t>KDQOL – Pain (a higher score is better)</a:t>
            </a:r>
            <a:r>
              <a:rPr lang="en-US" sz="2000" dirty="0"/>
              <a:t> - RS</a:t>
            </a:r>
          </a:p>
        </p:txBody>
      </p:sp>
      <p:pic>
        <p:nvPicPr>
          <p:cNvPr id="3" name="Picture 4" descr="A picture containing table&#10;&#10;Description automatically generated">
            <a:extLst>
              <a:ext uri="{FF2B5EF4-FFF2-40B4-BE49-F238E27FC236}">
                <a16:creationId xmlns:a16="http://schemas.microsoft.com/office/drawing/2014/main" id="{AF58FDF7-0D57-4996-8C7D-E12DA6725D4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5531" y="1265649"/>
            <a:ext cx="8640418" cy="26619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4146086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3">
            <a:extLst>
              <a:ext uri="{FF2B5EF4-FFF2-40B4-BE49-F238E27FC236}">
                <a16:creationId xmlns:a16="http://schemas.microsoft.com/office/drawing/2014/main" id="{2BA466B8-1321-AE4B-A475-D11804BC1F80}"/>
              </a:ext>
            </a:extLst>
          </p:cNvPr>
          <p:cNvSpPr txBox="1">
            <a:spLocks/>
          </p:cNvSpPr>
          <p:nvPr/>
        </p:nvSpPr>
        <p:spPr>
          <a:xfrm>
            <a:off x="189172" y="6185566"/>
            <a:ext cx="11559631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/>
              <a:t>Figure</a:t>
            </a:r>
            <a:r>
              <a:rPr lang="en-US" sz="2000">
                <a:ea typeface="+mj-lt"/>
                <a:cs typeface="+mj-lt"/>
              </a:rPr>
              <a:t> 11b. Forest plot – KDQOL – Physical health (a higher score is better)-</a:t>
            </a:r>
            <a:r>
              <a:rPr lang="en-US" sz="2000"/>
              <a:t> NRS</a:t>
            </a:r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D8713651-F972-E44A-8921-6616912E36DD}"/>
              </a:ext>
            </a:extLst>
          </p:cNvPr>
          <p:cNvSpPr txBox="1">
            <a:spLocks/>
          </p:cNvSpPr>
          <p:nvPr/>
        </p:nvSpPr>
        <p:spPr>
          <a:xfrm>
            <a:off x="189172" y="2872846"/>
            <a:ext cx="12172885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>
                <a:ea typeface="+mj-lt"/>
                <a:cs typeface="+mj-lt"/>
              </a:rPr>
              <a:t>Figure 11a. Forest plot – KDQOL – Physical health (a higher score is better)</a:t>
            </a:r>
            <a:r>
              <a:rPr lang="en-US" sz="2000" dirty="0">
                <a:solidFill>
                  <a:srgbClr val="FF0000"/>
                </a:solidFill>
              </a:rPr>
              <a:t> </a:t>
            </a:r>
            <a:r>
              <a:rPr lang="en-US" sz="2000" dirty="0"/>
              <a:t>- RS</a:t>
            </a:r>
            <a:endParaRPr lang="en-US" dirty="0"/>
          </a:p>
        </p:txBody>
      </p:sp>
      <p:pic>
        <p:nvPicPr>
          <p:cNvPr id="2" name="Picture 2">
            <a:extLst>
              <a:ext uri="{FF2B5EF4-FFF2-40B4-BE49-F238E27FC236}">
                <a16:creationId xmlns:a16="http://schemas.microsoft.com/office/drawing/2014/main" id="{2619BFCB-8548-408B-840D-2F5CEA847C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9161" y="169922"/>
            <a:ext cx="8416787" cy="2799264"/>
          </a:xfrm>
          <a:prstGeom prst="rect">
            <a:avLst/>
          </a:prstGeom>
        </p:spPr>
      </p:pic>
      <p:pic>
        <p:nvPicPr>
          <p:cNvPr id="9" name="Picture 9">
            <a:extLst>
              <a:ext uri="{FF2B5EF4-FFF2-40B4-BE49-F238E27FC236}">
                <a16:creationId xmlns:a16="http://schemas.microsoft.com/office/drawing/2014/main" id="{638C89CC-6AA0-49C3-A66F-E38E6D98B9A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9161" y="3463403"/>
            <a:ext cx="8052352" cy="28715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069363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61734171-A701-DD48-A4FA-630F174A68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1499" y="4216348"/>
            <a:ext cx="10515600" cy="585217"/>
          </a:xfrm>
        </p:spPr>
        <p:txBody>
          <a:bodyPr>
            <a:normAutofit/>
          </a:bodyPr>
          <a:lstStyle/>
          <a:p>
            <a:r>
              <a:rPr lang="en-US" sz="2000"/>
              <a:t>Figure 12. Forest plot – </a:t>
            </a:r>
            <a:r>
              <a:rPr lang="en-US" sz="2000" dirty="0">
                <a:ea typeface="+mj-lt"/>
                <a:cs typeface="+mj-lt"/>
              </a:rPr>
              <a:t>KDQOL – </a:t>
            </a:r>
            <a:r>
              <a:rPr lang="en-US" sz="2000">
                <a:ea typeface="+mj-lt"/>
                <a:cs typeface="+mj-lt"/>
              </a:rPr>
              <a:t>Mental health (a higher score is better)</a:t>
            </a:r>
            <a:r>
              <a:rPr lang="en-US" sz="2000"/>
              <a:t> - NRS</a:t>
            </a:r>
            <a:endParaRPr lang="en-US" sz="2000" dirty="0"/>
          </a:p>
        </p:txBody>
      </p:sp>
      <p:pic>
        <p:nvPicPr>
          <p:cNvPr id="2" name="Picture 4" descr="A picture containing text&#10;&#10;Description automatically generated">
            <a:extLst>
              <a:ext uri="{FF2B5EF4-FFF2-40B4-BE49-F238E27FC236}">
                <a16:creationId xmlns:a16="http://schemas.microsoft.com/office/drawing/2014/main" id="{BA598561-D1F9-4DDD-9743-AE6CF3B53CF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3509" y="1017429"/>
            <a:ext cx="8259417" cy="28932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797117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61734171-A701-DD48-A4FA-630F174A68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1499" y="4216348"/>
            <a:ext cx="10515600" cy="585217"/>
          </a:xfrm>
        </p:spPr>
        <p:txBody>
          <a:bodyPr>
            <a:normAutofit/>
          </a:bodyPr>
          <a:lstStyle/>
          <a:p>
            <a:r>
              <a:rPr lang="en-US" sz="2000" dirty="0"/>
              <a:t>Figure 13. Forest plot – </a:t>
            </a:r>
            <a:r>
              <a:rPr lang="en-US" sz="2000" dirty="0">
                <a:ea typeface="+mj-lt"/>
                <a:cs typeface="+mj-lt"/>
              </a:rPr>
              <a:t>Pruritus</a:t>
            </a:r>
            <a:r>
              <a:rPr lang="en-US" sz="2000" dirty="0"/>
              <a:t> (a lower score is better) - RS</a:t>
            </a:r>
          </a:p>
        </p:txBody>
      </p:sp>
      <p:pic>
        <p:nvPicPr>
          <p:cNvPr id="3" name="Picture 4">
            <a:extLst>
              <a:ext uri="{FF2B5EF4-FFF2-40B4-BE49-F238E27FC236}">
                <a16:creationId xmlns:a16="http://schemas.microsoft.com/office/drawing/2014/main" id="{355BDF76-1299-4C36-9FBB-5B49E790778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3509" y="1221628"/>
            <a:ext cx="8590721" cy="2625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6248285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61734171-A701-DD48-A4FA-630F174A68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82912" y="4083826"/>
            <a:ext cx="10515600" cy="585217"/>
          </a:xfrm>
        </p:spPr>
        <p:txBody>
          <a:bodyPr>
            <a:normAutofit/>
          </a:bodyPr>
          <a:lstStyle/>
          <a:p>
            <a:r>
              <a:rPr lang="en-US" sz="2000" dirty="0"/>
              <a:t>Figure 14. Forest plot – </a:t>
            </a:r>
            <a:r>
              <a:rPr lang="en-US" sz="2000" dirty="0">
                <a:ea typeface="+mj-lt"/>
                <a:cs typeface="+mj-lt"/>
              </a:rPr>
              <a:t>Recovery time</a:t>
            </a:r>
            <a:r>
              <a:rPr lang="en-US" sz="2000" dirty="0"/>
              <a:t> (a lower score is better) - NRS</a:t>
            </a:r>
          </a:p>
        </p:txBody>
      </p:sp>
      <p:pic>
        <p:nvPicPr>
          <p:cNvPr id="2" name="Picture 4">
            <a:extLst>
              <a:ext uri="{FF2B5EF4-FFF2-40B4-BE49-F238E27FC236}">
                <a16:creationId xmlns:a16="http://schemas.microsoft.com/office/drawing/2014/main" id="{5DCABC5E-85EA-4643-8D66-C277D25FFE9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6031" y="1383914"/>
            <a:ext cx="7928112" cy="24750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057034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61734171-A701-DD48-A4FA-630F174A68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1499" y="4216348"/>
            <a:ext cx="10515600" cy="585217"/>
          </a:xfrm>
        </p:spPr>
        <p:txBody>
          <a:bodyPr>
            <a:normAutofit/>
          </a:bodyPr>
          <a:lstStyle/>
          <a:p>
            <a:r>
              <a:rPr lang="en-US" sz="2000"/>
              <a:t>Figure 15. Forest plot – </a:t>
            </a:r>
            <a:r>
              <a:rPr lang="en-US" sz="2000">
                <a:ea typeface="+mj-lt"/>
                <a:cs typeface="+mj-lt"/>
              </a:rPr>
              <a:t>Restless Legs Syndrome </a:t>
            </a:r>
            <a:r>
              <a:rPr lang="en-US" sz="2000"/>
              <a:t>(</a:t>
            </a:r>
            <a:r>
              <a:rPr lang="en-US" sz="2000">
                <a:ea typeface="+mj-lt"/>
                <a:cs typeface="+mj-lt"/>
              </a:rPr>
              <a:t>NIH Diagnostic Criteria</a:t>
            </a:r>
            <a:r>
              <a:rPr lang="en-US" sz="2000"/>
              <a:t>) - NRS</a:t>
            </a:r>
          </a:p>
        </p:txBody>
      </p:sp>
      <p:pic>
        <p:nvPicPr>
          <p:cNvPr id="5" name="Picture 5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32F3424B-C44A-4853-908E-803F3B1B2F9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7444" y="1158029"/>
            <a:ext cx="8118611" cy="27860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2939446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61734171-A701-DD48-A4FA-630F174A68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1499" y="4216348"/>
            <a:ext cx="10515600" cy="585217"/>
          </a:xfrm>
        </p:spPr>
        <p:txBody>
          <a:bodyPr>
            <a:normAutofit fontScale="90000"/>
          </a:bodyPr>
          <a:lstStyle/>
          <a:p>
            <a:r>
              <a:rPr lang="en-US" sz="2000"/>
              <a:t>Figure 16. Forest plot – </a:t>
            </a:r>
            <a:r>
              <a:rPr lang="en-US" sz="2000">
                <a:ea typeface="+mj-lt"/>
                <a:cs typeface="+mj-lt"/>
              </a:rPr>
              <a:t>Symptom Severity </a:t>
            </a:r>
            <a:r>
              <a:rPr lang="en-US" sz="2000"/>
              <a:t>(</a:t>
            </a:r>
            <a:r>
              <a:rPr lang="en-US" sz="2000">
                <a:ea typeface="+mj-lt"/>
                <a:cs typeface="+mj-lt"/>
              </a:rPr>
              <a:t>Proportion of patients with 1 or more symptoms rated "severe" or "overwhelming"</a:t>
            </a:r>
            <a:r>
              <a:rPr lang="en-US" sz="2000"/>
              <a:t>) - NRS</a:t>
            </a:r>
          </a:p>
        </p:txBody>
      </p:sp>
      <p:pic>
        <p:nvPicPr>
          <p:cNvPr id="2" name="Picture 4">
            <a:extLst>
              <a:ext uri="{FF2B5EF4-FFF2-40B4-BE49-F238E27FC236}">
                <a16:creationId xmlns:a16="http://schemas.microsoft.com/office/drawing/2014/main" id="{83AC47EE-5E38-49B5-8122-EF094606691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3509" y="2074952"/>
            <a:ext cx="9137373" cy="15982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541998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61734171-A701-DD48-A4FA-630F174A68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1499" y="4216348"/>
            <a:ext cx="10515600" cy="585217"/>
          </a:xfrm>
        </p:spPr>
        <p:txBody>
          <a:bodyPr>
            <a:normAutofit/>
          </a:bodyPr>
          <a:lstStyle/>
          <a:p>
            <a:r>
              <a:rPr lang="en-US" sz="2000" dirty="0"/>
              <a:t>Figure 17. Forest plot – </a:t>
            </a:r>
            <a:r>
              <a:rPr lang="en-US" sz="2000" dirty="0">
                <a:ea typeface="+mj-lt"/>
                <a:cs typeface="+mj-lt"/>
              </a:rPr>
              <a:t>Erythropoiesis resistance index </a:t>
            </a:r>
            <a:r>
              <a:rPr lang="en-US" sz="2000"/>
              <a:t> - RS</a:t>
            </a:r>
            <a:endParaRPr lang="en-US" sz="2000" dirty="0"/>
          </a:p>
        </p:txBody>
      </p:sp>
      <p:pic>
        <p:nvPicPr>
          <p:cNvPr id="2" name="Picture 2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49993693-34AF-48A3-B881-88D61FDA7F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3206" y="1182075"/>
            <a:ext cx="8035785" cy="27130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7797197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61734171-A701-DD48-A4FA-630F174A68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1499" y="4216348"/>
            <a:ext cx="10515600" cy="585217"/>
          </a:xfrm>
        </p:spPr>
        <p:txBody>
          <a:bodyPr>
            <a:normAutofit/>
          </a:bodyPr>
          <a:lstStyle/>
          <a:p>
            <a:r>
              <a:rPr lang="en-US" sz="2000" dirty="0"/>
              <a:t>Figure 18. Forest plot – </a:t>
            </a:r>
            <a:r>
              <a:rPr lang="en-US" sz="2000" dirty="0">
                <a:ea typeface="+mj-lt"/>
                <a:cs typeface="+mj-lt"/>
              </a:rPr>
              <a:t>Iron utilization</a:t>
            </a:r>
            <a:r>
              <a:rPr lang="en-US" sz="2000"/>
              <a:t> - RS</a:t>
            </a:r>
            <a:endParaRPr lang="en-US" sz="2000" dirty="0"/>
          </a:p>
        </p:txBody>
      </p:sp>
      <p:pic>
        <p:nvPicPr>
          <p:cNvPr id="2" name="Picture 2">
            <a:extLst>
              <a:ext uri="{FF2B5EF4-FFF2-40B4-BE49-F238E27FC236}">
                <a16:creationId xmlns:a16="http://schemas.microsoft.com/office/drawing/2014/main" id="{2B3B2A9D-EF94-4B65-BEDB-106D30D5AC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7554" y="1212194"/>
            <a:ext cx="8391937" cy="27688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587857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3">
            <a:extLst>
              <a:ext uri="{FF2B5EF4-FFF2-40B4-BE49-F238E27FC236}">
                <a16:creationId xmlns:a16="http://schemas.microsoft.com/office/drawing/2014/main" id="{DFBC4418-AC4E-824B-9A31-96C32DC12113}"/>
              </a:ext>
            </a:extLst>
          </p:cNvPr>
          <p:cNvSpPr txBox="1">
            <a:spLocks/>
          </p:cNvSpPr>
          <p:nvPr/>
        </p:nvSpPr>
        <p:spPr>
          <a:xfrm>
            <a:off x="384314" y="2843783"/>
            <a:ext cx="10515600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/>
              <a:t>Figure 2a. Forest plot – Hospitalization – any cause; rate ratio (</a:t>
            </a:r>
            <a:r>
              <a:rPr lang="en-US" sz="2000" dirty="0">
                <a:ea typeface="+mj-lt"/>
                <a:cs typeface="+mj-lt"/>
              </a:rPr>
              <a:t>number of episodes of hospitalization for any reason</a:t>
            </a:r>
            <a:r>
              <a:rPr lang="en-US" sz="2000" dirty="0"/>
              <a:t>) - RS</a:t>
            </a:r>
          </a:p>
        </p:txBody>
      </p:sp>
      <p:pic>
        <p:nvPicPr>
          <p:cNvPr id="2" name="Picture 2">
            <a:extLst>
              <a:ext uri="{FF2B5EF4-FFF2-40B4-BE49-F238E27FC236}">
                <a16:creationId xmlns:a16="http://schemas.microsoft.com/office/drawing/2014/main" id="{D3990FEC-173E-477A-80FC-A9A77527BCD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4314" y="314252"/>
            <a:ext cx="8259416" cy="2478502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40016404-12CC-6442-B9F4-2BF8F51CB14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4314" y="3553853"/>
            <a:ext cx="7926917" cy="2630129"/>
          </a:xfrm>
          <a:prstGeom prst="rect">
            <a:avLst/>
          </a:prstGeom>
        </p:spPr>
      </p:pic>
      <p:sp>
        <p:nvSpPr>
          <p:cNvPr id="5" name="Title 3">
            <a:extLst>
              <a:ext uri="{FF2B5EF4-FFF2-40B4-BE49-F238E27FC236}">
                <a16:creationId xmlns:a16="http://schemas.microsoft.com/office/drawing/2014/main" id="{E388AE3E-700C-8740-966B-876364D02326}"/>
              </a:ext>
            </a:extLst>
          </p:cNvPr>
          <p:cNvSpPr txBox="1">
            <a:spLocks/>
          </p:cNvSpPr>
          <p:nvPr/>
        </p:nvSpPr>
        <p:spPr>
          <a:xfrm>
            <a:off x="384314" y="6183982"/>
            <a:ext cx="10515600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/>
              <a:t>Figure 2b. Forest plot – Hospitalization – any cause; rate ratio (</a:t>
            </a:r>
            <a:r>
              <a:rPr lang="en-US" sz="2000" dirty="0">
                <a:ea typeface="+mj-lt"/>
                <a:cs typeface="+mj-lt"/>
              </a:rPr>
              <a:t>number of episodes of hospitalization for any reason</a:t>
            </a:r>
            <a:r>
              <a:rPr lang="en-US" sz="2000" dirty="0"/>
              <a:t>) - NRS</a:t>
            </a:r>
          </a:p>
        </p:txBody>
      </p:sp>
    </p:spTree>
    <p:extLst>
      <p:ext uri="{BB962C8B-B14F-4D97-AF65-F5344CB8AC3E}">
        <p14:creationId xmlns:p14="http://schemas.microsoft.com/office/powerpoint/2010/main" val="30514355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61734171-A701-DD48-A4FA-630F174A68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9587" y="4026076"/>
            <a:ext cx="10515600" cy="585217"/>
          </a:xfrm>
        </p:spPr>
        <p:txBody>
          <a:bodyPr>
            <a:normAutofit/>
          </a:bodyPr>
          <a:lstStyle/>
          <a:p>
            <a:r>
              <a:rPr lang="en-US" sz="2000"/>
              <a:t>Figure 3. Forest plot – Hospitalization days / length of stay (</a:t>
            </a:r>
            <a:r>
              <a:rPr lang="en-US" sz="2000">
                <a:ea typeface="+mj-lt"/>
                <a:cs typeface="+mj-lt"/>
              </a:rPr>
              <a:t>number of days in hospital</a:t>
            </a:r>
            <a:r>
              <a:rPr lang="en-US" sz="2000"/>
              <a:t>) - NR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3CB545A-7855-46B0-ACE8-FE8A68E0754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3827" y="1164894"/>
            <a:ext cx="8753475" cy="26458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186787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61734171-A701-DD48-A4FA-630F174A68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75238" y="4199783"/>
            <a:ext cx="10515600" cy="585217"/>
          </a:xfrm>
        </p:spPr>
        <p:txBody>
          <a:bodyPr>
            <a:normAutofit/>
          </a:bodyPr>
          <a:lstStyle/>
          <a:p>
            <a:r>
              <a:rPr lang="en-US" sz="2000" dirty="0"/>
              <a:t>Figure 4. Forest plot – </a:t>
            </a:r>
            <a:r>
              <a:rPr lang="en-US" sz="2000" dirty="0">
                <a:ea typeface="+mj-lt"/>
                <a:cs typeface="+mj-lt"/>
              </a:rPr>
              <a:t>Serious adverse events (SAE)</a:t>
            </a:r>
            <a:r>
              <a:rPr lang="en-US" sz="2000" dirty="0"/>
              <a:t> (a lower rate is better) - RS</a:t>
            </a:r>
          </a:p>
        </p:txBody>
      </p:sp>
      <p:pic>
        <p:nvPicPr>
          <p:cNvPr id="2" name="Picture 2" descr="Text&#10;&#10;Description automatically generated">
            <a:extLst>
              <a:ext uri="{FF2B5EF4-FFF2-40B4-BE49-F238E27FC236}">
                <a16:creationId xmlns:a16="http://schemas.microsoft.com/office/drawing/2014/main" id="{019E210D-FDDC-4571-B01C-34BB7EA6CC1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4618" y="1311910"/>
            <a:ext cx="8118612" cy="2842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604009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61734171-A701-DD48-A4FA-630F174A68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1499" y="3429000"/>
            <a:ext cx="10515600" cy="585217"/>
          </a:xfrm>
        </p:spPr>
        <p:txBody>
          <a:bodyPr>
            <a:normAutofit/>
          </a:bodyPr>
          <a:lstStyle/>
          <a:p>
            <a:r>
              <a:rPr lang="en-US" sz="2000"/>
              <a:t>Figure 5. </a:t>
            </a:r>
            <a:r>
              <a:rPr lang="en-US" sz="2000" dirty="0"/>
              <a:t>Forest plot – Any infection (a lower rate is better) - NRS</a:t>
            </a:r>
          </a:p>
        </p:txBody>
      </p:sp>
      <p:pic>
        <p:nvPicPr>
          <p:cNvPr id="2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F24F067C-E3F8-4045-B1DC-08D114E1B70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1499" y="334442"/>
            <a:ext cx="7538829" cy="30945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565199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3">
            <a:extLst>
              <a:ext uri="{FF2B5EF4-FFF2-40B4-BE49-F238E27FC236}">
                <a16:creationId xmlns:a16="http://schemas.microsoft.com/office/drawing/2014/main" id="{2BA466B8-1321-AE4B-A475-D11804BC1F80}"/>
              </a:ext>
            </a:extLst>
          </p:cNvPr>
          <p:cNvSpPr txBox="1">
            <a:spLocks/>
          </p:cNvSpPr>
          <p:nvPr/>
        </p:nvSpPr>
        <p:spPr>
          <a:xfrm>
            <a:off x="189173" y="3824594"/>
            <a:ext cx="10515600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/>
              <a:t>Figure 6. Forest plot – Quality of life (overall score - a higher score is better) - NRS</a:t>
            </a:r>
          </a:p>
        </p:txBody>
      </p:sp>
      <p:pic>
        <p:nvPicPr>
          <p:cNvPr id="3" name="Picture 4">
            <a:extLst>
              <a:ext uri="{FF2B5EF4-FFF2-40B4-BE49-F238E27FC236}">
                <a16:creationId xmlns:a16="http://schemas.microsoft.com/office/drawing/2014/main" id="{7D949A4D-652C-4280-B6FB-30D9450CA8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1987" y="1109031"/>
            <a:ext cx="8052351" cy="26438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9176773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3">
            <a:extLst>
              <a:ext uri="{FF2B5EF4-FFF2-40B4-BE49-F238E27FC236}">
                <a16:creationId xmlns:a16="http://schemas.microsoft.com/office/drawing/2014/main" id="{2BA466B8-1321-AE4B-A475-D11804BC1F80}"/>
              </a:ext>
            </a:extLst>
          </p:cNvPr>
          <p:cNvSpPr txBox="1">
            <a:spLocks/>
          </p:cNvSpPr>
          <p:nvPr/>
        </p:nvSpPr>
        <p:spPr>
          <a:xfrm>
            <a:off x="114628" y="4189457"/>
            <a:ext cx="11559631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/>
              <a:t>Figure 7. Forest plot – KDQOL – Burden of Kidney Disease (a higher score is better) - NRS</a:t>
            </a:r>
          </a:p>
        </p:txBody>
      </p:sp>
      <p:pic>
        <p:nvPicPr>
          <p:cNvPr id="5" name="Picture 5">
            <a:extLst>
              <a:ext uri="{FF2B5EF4-FFF2-40B4-BE49-F238E27FC236}">
                <a16:creationId xmlns:a16="http://schemas.microsoft.com/office/drawing/2014/main" id="{826D2EC0-DB5D-4068-829B-9EE4E392F2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0684" y="1436131"/>
            <a:ext cx="8309111" cy="27930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4177296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3">
            <a:extLst>
              <a:ext uri="{FF2B5EF4-FFF2-40B4-BE49-F238E27FC236}">
                <a16:creationId xmlns:a16="http://schemas.microsoft.com/office/drawing/2014/main" id="{2BA466B8-1321-AE4B-A475-D11804BC1F80}"/>
              </a:ext>
            </a:extLst>
          </p:cNvPr>
          <p:cNvSpPr txBox="1">
            <a:spLocks/>
          </p:cNvSpPr>
          <p:nvPr/>
        </p:nvSpPr>
        <p:spPr>
          <a:xfrm>
            <a:off x="122911" y="3965827"/>
            <a:ext cx="11831481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/>
              <a:t>Figure 8. Forest plot – KDQOL – Effects of Kidney Disease (a higher score is better) - NRS</a:t>
            </a:r>
          </a:p>
        </p:txBody>
      </p:sp>
      <p:pic>
        <p:nvPicPr>
          <p:cNvPr id="2" name="Picture 2" descr="A picture containing table&#10;&#10;Description automatically generated">
            <a:extLst>
              <a:ext uri="{FF2B5EF4-FFF2-40B4-BE49-F238E27FC236}">
                <a16:creationId xmlns:a16="http://schemas.microsoft.com/office/drawing/2014/main" id="{03661128-11A0-40C9-9D8E-6557EB54581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8356" y="1238191"/>
            <a:ext cx="8449917" cy="26422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6513687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3">
            <a:extLst>
              <a:ext uri="{FF2B5EF4-FFF2-40B4-BE49-F238E27FC236}">
                <a16:creationId xmlns:a16="http://schemas.microsoft.com/office/drawing/2014/main" id="{2BA466B8-1321-AE4B-A475-D11804BC1F80}"/>
              </a:ext>
            </a:extLst>
          </p:cNvPr>
          <p:cNvSpPr txBox="1">
            <a:spLocks/>
          </p:cNvSpPr>
          <p:nvPr/>
        </p:nvSpPr>
        <p:spPr>
          <a:xfrm>
            <a:off x="189172" y="6185566"/>
            <a:ext cx="11559631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/>
              <a:t>Figure</a:t>
            </a:r>
            <a:r>
              <a:rPr lang="en-US" sz="2000">
                <a:ea typeface="+mj-lt"/>
                <a:cs typeface="+mj-lt"/>
              </a:rPr>
              <a:t> 8b. Forest plot – KDQOL and E-SAS – Symptoms/Problem List (a higher score is better)-</a:t>
            </a:r>
            <a:r>
              <a:rPr lang="en-US" sz="2000"/>
              <a:t> NRS</a:t>
            </a:r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D8713651-F972-E44A-8921-6616912E36DD}"/>
              </a:ext>
            </a:extLst>
          </p:cNvPr>
          <p:cNvSpPr txBox="1">
            <a:spLocks/>
          </p:cNvSpPr>
          <p:nvPr/>
        </p:nvSpPr>
        <p:spPr>
          <a:xfrm>
            <a:off x="189172" y="2823150"/>
            <a:ext cx="12172885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>
                <a:ea typeface="+mj-lt"/>
                <a:cs typeface="+mj-lt"/>
              </a:rPr>
              <a:t>Figure 9a. Forest plot – KDQOL – Symptoms/Problem List (a higher score is better)</a:t>
            </a:r>
            <a:r>
              <a:rPr lang="en-US" sz="2000" dirty="0">
                <a:solidFill>
                  <a:srgbClr val="FF0000"/>
                </a:solidFill>
              </a:rPr>
              <a:t> </a:t>
            </a:r>
            <a:r>
              <a:rPr lang="en-US" sz="2000"/>
              <a:t>- RS</a:t>
            </a:r>
            <a:endParaRPr lang="en-US"/>
          </a:p>
        </p:txBody>
      </p:sp>
      <p:pic>
        <p:nvPicPr>
          <p:cNvPr id="5" name="Picture 5">
            <a:extLst>
              <a:ext uri="{FF2B5EF4-FFF2-40B4-BE49-F238E27FC236}">
                <a16:creationId xmlns:a16="http://schemas.microsoft.com/office/drawing/2014/main" id="{8A0E7612-D189-47B5-A5C1-7A017A3F506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1487" y="186158"/>
            <a:ext cx="8524460" cy="2675683"/>
          </a:xfrm>
          <a:prstGeom prst="rect">
            <a:avLst/>
          </a:prstGeom>
        </p:spPr>
      </p:pic>
      <p:pic>
        <p:nvPicPr>
          <p:cNvPr id="6" name="Picture 7" descr="A picture containing diagram&#10;&#10;Description automatically generated">
            <a:extLst>
              <a:ext uri="{FF2B5EF4-FFF2-40B4-BE49-F238E27FC236}">
                <a16:creationId xmlns:a16="http://schemas.microsoft.com/office/drawing/2014/main" id="{3793D787-EA1E-45B4-9122-3779DD857C6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1487" y="3368718"/>
            <a:ext cx="8673547" cy="29532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273266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66</TotalTime>
  <Words>424</Words>
  <Application>Microsoft Macintosh PowerPoint</Application>
  <PresentationFormat>Widescreen</PresentationFormat>
  <Paragraphs>22</Paragraphs>
  <Slides>1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22" baseType="lpstr">
      <vt:lpstr>Arial</vt:lpstr>
      <vt:lpstr>Calibri</vt:lpstr>
      <vt:lpstr>Calibri Light</vt:lpstr>
      <vt:lpstr>Office Theme</vt:lpstr>
      <vt:lpstr>Figure 1a. Forest plot – all-cause mortality (number of deaths from any cause) - RS.</vt:lpstr>
      <vt:lpstr>PowerPoint Presentation</vt:lpstr>
      <vt:lpstr>Figure 3. Forest plot – Hospitalization days / length of stay (number of days in hospital) - NRS</vt:lpstr>
      <vt:lpstr>Figure 4. Forest plot – Serious adverse events (SAE) (a lower rate is better) - RS</vt:lpstr>
      <vt:lpstr>Figure 5. Forest plot – Any infection (a lower rate is better) - NRS</vt:lpstr>
      <vt:lpstr>PowerPoint Presentation</vt:lpstr>
      <vt:lpstr>PowerPoint Presentation</vt:lpstr>
      <vt:lpstr>PowerPoint Presentation</vt:lpstr>
      <vt:lpstr>PowerPoint Presentation</vt:lpstr>
      <vt:lpstr>Figure 10. Forest plot – KDQOL – Pain (a higher score is better) - RS</vt:lpstr>
      <vt:lpstr>PowerPoint Presentation</vt:lpstr>
      <vt:lpstr>Figure 12. Forest plot – KDQOL – Mental health (a higher score is better) - NRS</vt:lpstr>
      <vt:lpstr>Figure 13. Forest plot – Pruritus (a lower score is better) - RS</vt:lpstr>
      <vt:lpstr>Figure 14. Forest plot – Recovery time (a lower score is better) - NRS</vt:lpstr>
      <vt:lpstr>Figure 15. Forest plot – Restless Legs Syndrome (NIH Diagnostic Criteria) - NRS</vt:lpstr>
      <vt:lpstr>Figure 16. Forest plot – Symptom Severity (Proportion of patients with 1 or more symptoms rated "severe" or "overwhelming") - NRS</vt:lpstr>
      <vt:lpstr>Figure 17. Forest plot – Erythropoiesis resistance index  - RS</vt:lpstr>
      <vt:lpstr>Figure 18. Forest plot – Iron utilization - R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. Forest plot – all-cause mortality</dc:title>
  <dc:creator>Gihad Nesrallah</dc:creator>
  <cp:lastModifiedBy>Gihad Nesrallah</cp:lastModifiedBy>
  <cp:revision>558</cp:revision>
  <dcterms:created xsi:type="dcterms:W3CDTF">2020-08-29T20:16:17Z</dcterms:created>
  <dcterms:modified xsi:type="dcterms:W3CDTF">2021-06-26T15:50:50Z</dcterms:modified>
</cp:coreProperties>
</file>